
<file path=[Content_Types].xml><?xml version="1.0" encoding="utf-8"?>
<Types xmlns="http://schemas.openxmlformats.org/package/2006/content-types"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6"/>
  </p:notesMasterIdLst>
  <p:sldIdLst>
    <p:sldId id="283" r:id="rId2"/>
    <p:sldId id="288" r:id="rId3"/>
    <p:sldId id="289" r:id="rId4"/>
    <p:sldId id="264" r:id="rId5"/>
    <p:sldId id="290" r:id="rId6"/>
    <p:sldId id="284" r:id="rId7"/>
    <p:sldId id="285" r:id="rId8"/>
    <p:sldId id="281" r:id="rId9"/>
    <p:sldId id="279" r:id="rId10"/>
    <p:sldId id="282" r:id="rId11"/>
    <p:sldId id="287" r:id="rId12"/>
    <p:sldId id="268" r:id="rId13"/>
    <p:sldId id="291" r:id="rId14"/>
    <p:sldId id="286" r:id="rId1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bianca lear" initials="bl" lastIdx="2" clrIdx="0">
    <p:extLst>
      <p:ext uri="{19B8F6BF-5375-455C-9EA6-DF929625EA0E}">
        <p15:presenceInfo xmlns:p15="http://schemas.microsoft.com/office/powerpoint/2012/main" userId="083bf0d942cb4ae6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3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786" autoAdjust="0"/>
    <p:restoredTop sz="94660"/>
  </p:normalViewPr>
  <p:slideViewPr>
    <p:cSldViewPr snapToGrid="0">
      <p:cViewPr>
        <p:scale>
          <a:sx n="110" d="100"/>
          <a:sy n="110" d="100"/>
        </p:scale>
        <p:origin x="798" y="-12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65" d="100"/>
          <a:sy n="65" d="100"/>
        </p:scale>
        <p:origin x="3154" y="48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commentAuthors" Target="commentAuthors.xml"/><Relationship Id="rId2" Type="http://schemas.openxmlformats.org/officeDocument/2006/relationships/slide" Target="slides/slide1.xml"/><Relationship Id="rId16" Type="http://schemas.openxmlformats.org/officeDocument/2006/relationships/notesMaster" Target="notesMasters/notesMaster1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30E2866-8687-4ED1-B1EC-06B9270C20C3}" type="datetimeFigureOut">
              <a:rPr lang="en-GB" smtClean="0"/>
              <a:t>08/03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9C6879A-2E43-4A0B-993F-F24B00C9D2F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35369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49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86" indent="0" algn="ctr">
              <a:buNone/>
              <a:defRPr sz="1499"/>
            </a:lvl2pPr>
            <a:lvl3pPr marL="685771" indent="0" algn="ctr">
              <a:buNone/>
              <a:defRPr sz="1351"/>
            </a:lvl3pPr>
            <a:lvl4pPr marL="1028657" indent="0" algn="ctr">
              <a:buNone/>
              <a:defRPr sz="1200"/>
            </a:lvl4pPr>
            <a:lvl5pPr marL="1371543" indent="0" algn="ctr">
              <a:buNone/>
              <a:defRPr sz="1200"/>
            </a:lvl5pPr>
            <a:lvl6pPr marL="1714428" indent="0" algn="ctr">
              <a:buNone/>
              <a:defRPr sz="1200"/>
            </a:lvl6pPr>
            <a:lvl7pPr marL="2057314" indent="0" algn="ctr">
              <a:buNone/>
              <a:defRPr sz="1200"/>
            </a:lvl7pPr>
            <a:lvl8pPr marL="2400200" indent="0" algn="ctr">
              <a:buNone/>
              <a:defRPr sz="1200"/>
            </a:lvl8pPr>
            <a:lvl9pPr marL="2743085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CF14-1915-4B9C-8FCA-FFE9C9C8F0C1}" type="datetimeFigureOut">
              <a:rPr lang="en-GB" smtClean="0"/>
              <a:t>08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4E066-27B0-41B6-8A60-19378FCEA6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34203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CF14-1915-4B9C-8FCA-FFE9C9C8F0C1}" type="datetimeFigureOut">
              <a:rPr lang="en-GB" smtClean="0"/>
              <a:t>08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4E066-27B0-41B6-8A60-19378FCEA6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84173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CF14-1915-4B9C-8FCA-FFE9C9C8F0C1}" type="datetimeFigureOut">
              <a:rPr lang="en-GB" smtClean="0"/>
              <a:t>08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4E066-27B0-41B6-8A60-19378FCEA6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14637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CF14-1915-4B9C-8FCA-FFE9C9C8F0C1}" type="datetimeFigureOut">
              <a:rPr lang="en-GB" smtClean="0"/>
              <a:t>08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4E066-27B0-41B6-8A60-19378FCEA6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91837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49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86" indent="0">
              <a:buNone/>
              <a:defRPr sz="1499">
                <a:solidFill>
                  <a:schemeClr val="tx1">
                    <a:tint val="75000"/>
                  </a:schemeClr>
                </a:solidFill>
              </a:defRPr>
            </a:lvl2pPr>
            <a:lvl3pPr marL="685771" indent="0">
              <a:buNone/>
              <a:defRPr sz="1351">
                <a:solidFill>
                  <a:schemeClr val="tx1">
                    <a:tint val="75000"/>
                  </a:schemeClr>
                </a:solidFill>
              </a:defRPr>
            </a:lvl3pPr>
            <a:lvl4pPr marL="10286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4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2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08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CF14-1915-4B9C-8FCA-FFE9C9C8F0C1}" type="datetimeFigureOut">
              <a:rPr lang="en-GB" smtClean="0"/>
              <a:t>08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4E066-27B0-41B6-8A60-19378FCEA6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29872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CF14-1915-4B9C-8FCA-FFE9C9C8F0C1}" type="datetimeFigureOut">
              <a:rPr lang="en-GB" smtClean="0"/>
              <a:t>08/03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4E066-27B0-41B6-8A60-19378FCEA6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00822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6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499" b="1"/>
            </a:lvl2pPr>
            <a:lvl3pPr marL="685771" indent="0">
              <a:buNone/>
              <a:defRPr sz="1351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200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499" b="1"/>
            </a:lvl2pPr>
            <a:lvl3pPr marL="685771" indent="0">
              <a:buNone/>
              <a:defRPr sz="1351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200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CF14-1915-4B9C-8FCA-FFE9C9C8F0C1}" type="datetimeFigureOut">
              <a:rPr lang="en-GB" smtClean="0"/>
              <a:t>08/03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4E066-27B0-41B6-8A60-19378FCEA6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72784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CF14-1915-4B9C-8FCA-FFE9C9C8F0C1}" type="datetimeFigureOut">
              <a:rPr lang="en-GB" smtClean="0"/>
              <a:t>08/03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4E066-27B0-41B6-8A60-19378FCEA6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01851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CF14-1915-4B9C-8FCA-FFE9C9C8F0C1}" type="datetimeFigureOut">
              <a:rPr lang="en-GB" smtClean="0"/>
              <a:t>08/03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4E066-27B0-41B6-8A60-19378FCEA6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00499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4"/>
            <a:ext cx="3471863" cy="7039681"/>
          </a:xfrm>
        </p:spPr>
        <p:txBody>
          <a:bodyPr/>
          <a:lstStyle>
            <a:lvl1pPr>
              <a:defRPr sz="2401"/>
            </a:lvl1pPr>
            <a:lvl2pPr>
              <a:defRPr sz="2100"/>
            </a:lvl2pPr>
            <a:lvl3pPr>
              <a:defRPr sz="1800"/>
            </a:lvl3pPr>
            <a:lvl4pPr>
              <a:defRPr sz="1499"/>
            </a:lvl4pPr>
            <a:lvl5pPr>
              <a:defRPr sz="1499"/>
            </a:lvl5pPr>
            <a:lvl6pPr>
              <a:defRPr sz="1499"/>
            </a:lvl6pPr>
            <a:lvl7pPr>
              <a:defRPr sz="1499"/>
            </a:lvl7pPr>
            <a:lvl8pPr>
              <a:defRPr sz="1499"/>
            </a:lvl8pPr>
            <a:lvl9pPr>
              <a:defRPr sz="149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1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200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CF14-1915-4B9C-8FCA-FFE9C9C8F0C1}" type="datetimeFigureOut">
              <a:rPr lang="en-GB" smtClean="0"/>
              <a:t>08/03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4E066-27B0-41B6-8A60-19378FCEA6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32395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4"/>
            <a:ext cx="3471863" cy="7039681"/>
          </a:xfrm>
        </p:spPr>
        <p:txBody>
          <a:bodyPr anchor="t"/>
          <a:lstStyle>
            <a:lvl1pPr marL="0" indent="0">
              <a:buNone/>
              <a:defRPr sz="2401"/>
            </a:lvl1pPr>
            <a:lvl2pPr marL="342886" indent="0">
              <a:buNone/>
              <a:defRPr sz="2100"/>
            </a:lvl2pPr>
            <a:lvl3pPr marL="685771" indent="0">
              <a:buNone/>
              <a:defRPr sz="1800"/>
            </a:lvl3pPr>
            <a:lvl4pPr marL="1028657" indent="0">
              <a:buNone/>
              <a:defRPr sz="1499"/>
            </a:lvl4pPr>
            <a:lvl5pPr marL="1371543" indent="0">
              <a:buNone/>
              <a:defRPr sz="1499"/>
            </a:lvl5pPr>
            <a:lvl6pPr marL="1714428" indent="0">
              <a:buNone/>
              <a:defRPr sz="1499"/>
            </a:lvl6pPr>
            <a:lvl7pPr marL="2057314" indent="0">
              <a:buNone/>
              <a:defRPr sz="1499"/>
            </a:lvl7pPr>
            <a:lvl8pPr marL="2400200" indent="0">
              <a:buNone/>
              <a:defRPr sz="1499"/>
            </a:lvl8pPr>
            <a:lvl9pPr marL="2743085" indent="0">
              <a:buNone/>
              <a:defRPr sz="1499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1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200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CF14-1915-4B9C-8FCA-FFE9C9C8F0C1}" type="datetimeFigureOut">
              <a:rPr lang="en-GB" smtClean="0"/>
              <a:t>08/03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4E066-27B0-41B6-8A60-19378FCEA6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45707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11CF14-1915-4B9C-8FCA-FFE9C9C8F0C1}" type="datetimeFigureOut">
              <a:rPr lang="en-GB" smtClean="0"/>
              <a:t>08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D4E066-27B0-41B6-8A60-19378FCEA6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06539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771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3" indent="-171443" algn="l" defTabSz="685771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29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14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499" kern="1200">
          <a:solidFill>
            <a:schemeClr val="tx1"/>
          </a:solidFill>
          <a:latin typeface="+mn-lt"/>
          <a:ea typeface="+mn-ea"/>
          <a:cs typeface="+mn-cs"/>
        </a:defRPr>
      </a:lvl3pPr>
      <a:lvl4pPr marL="1200100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542986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885871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228757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571643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914528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1pPr>
      <a:lvl2pPr marL="342886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2pPr>
      <a:lvl3pPr marL="685771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3pPr>
      <a:lvl4pPr marL="1028657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371543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714428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057314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400200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743085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021814" y="900630"/>
            <a:ext cx="48143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Lear et al. Supplementary Figures and Tables</a:t>
            </a:r>
            <a:endParaRPr lang="en-US" dirty="0"/>
          </a:p>
        </p:txBody>
      </p:sp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58298984"/>
              </p:ext>
            </p:extLst>
          </p:nvPr>
        </p:nvGraphicFramePr>
        <p:xfrm>
          <a:off x="478632" y="3135672"/>
          <a:ext cx="5900736" cy="3499023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258630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5193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3462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31630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31120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 name</a:t>
                      </a:r>
                    </a:p>
                    <a:p>
                      <a:pPr algn="l" fontAlgn="b"/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013" marR="3013" marT="3013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 ID (locus)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013" marR="3013" marT="3013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 primer</a:t>
                      </a:r>
                    </a:p>
                    <a:p>
                      <a:pPr algn="l" fontAlgn="b"/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013" marR="3013" marT="3013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 primer</a:t>
                      </a:r>
                    </a:p>
                    <a:p>
                      <a:pPr algn="l" fontAlgn="b"/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013" marR="3013" marT="3013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77333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GE5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UDP-glucose 4-epimeras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013" marR="3013" marT="3013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217950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013" marR="3013" marT="3013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AACTGAACTGGAAGGCGA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013" marR="3013" marT="3013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TCTTGAGGTCCATAGCC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013" marR="3013" marT="3013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77333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P2 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9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lactinol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sucrose galactosyltransferase 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013" marR="3013" marT="3013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219194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013" marR="3013" marT="3013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TTCAACTCCAGTGGTGC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013" marR="3013" marT="3013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TTTTGATGGTGACTGTGGC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013" marR="3013" marT="3013" marB="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77333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N10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</a:t>
                      </a:r>
                      <a:r>
                        <a:rPr lang="en-US" sz="9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lactinol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sucrose galactosyltransferase 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013" marR="3013" marT="3013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218683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013" marR="3013" marT="3013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TTAGAGGGTGTGGCAAG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013" marR="3013" marT="3013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GTCACCAACCCAGATGCC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013" marR="3013" marT="3013" marB="0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77333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BF1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beta-</a:t>
                      </a:r>
                      <a:r>
                        <a:rPr lang="en-US" sz="9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ructofuranosidas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013" marR="3013" marT="3013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218748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013" marR="3013" marT="3013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GGGCATTTGTAACTGTGGA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013" marR="3013" marT="3013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TTGAAAGCATATAAGTGGGCATC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013" marR="3013" marT="3013" marB="0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77333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GM2 </a:t>
                      </a:r>
                      <a:r>
                        <a:rPr lang="en-US" sz="9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osphoglucomutase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cytoplasmic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013" marR="3013" marT="3013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219797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013" marR="3013" marT="3013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CAACCATTCGTCTCTACA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013" marR="3013" marT="3013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AGATCGGCCAGTGAATTC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013" marR="3013" marT="3013" marB="0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77333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AL3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lpha-galactosidase 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013" marR="3013" marT="3013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218518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013" marR="3013" marT="3013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AATCGGGGTTCAACAGCA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013" marR="3013" marT="3013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AGAGCACCAAATGAGG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013" marR="3013" marT="3013" marB="0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77333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MT1 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9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ffeic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cid 3-O-methyltransferas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013" marR="3013" marT="3013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218468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013" marR="3013" marT="3013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TGCAGCGCTTCCAGACAA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013" marR="3013" marT="3013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GCCAACATGATCACGTCG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013" marR="3013" marT="3013" marB="0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77333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XPX 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oxidase 4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013" marR="3013" marT="3013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216757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013" marR="3013" marT="3013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GTGAGAAATGACCGTGG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013" marR="3013" marT="3013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TCCTCTTGTCTGTGGCA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013" marR="3013" marT="3013" marB="0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77333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D9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9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nnamyl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alcohol dehydrogenase 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013" marR="3013" marT="3013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218498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013" marR="3013" marT="3013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GAAACTGGTTACTGTTGGG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013" marR="3013" marT="3013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ATCCCTCCAACGTCGCT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013" marR="3013" marT="3013" marB="0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77333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CT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hikimate o-</a:t>
                      </a:r>
                      <a:r>
                        <a:rPr lang="en-US" sz="9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droxy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r>
                        <a:rPr lang="en-US" sz="9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nnamoyltransferas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013" marR="3013" marT="3013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220140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013" marR="3013" marT="3013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TTTACGCTGCCCCTCTA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013" marR="3013" marT="3013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TGTTCATATGCCGAGAATGC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013" marR="3013" marT="3013" marB="0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399253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PC2</a:t>
                      </a:r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glyceraldehyde-phosphate dehydrogenase, cytosolic</a:t>
                      </a:r>
                    </a:p>
                  </a:txBody>
                  <a:tcPr marL="3013" marR="3013" marT="3013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2179622</a:t>
                      </a:r>
                    </a:p>
                    <a:p>
                      <a:pPr algn="l" fontAlgn="b"/>
                      <a:endParaRPr lang="en-US" sz="90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013" marR="3013" marT="3013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TTGAGAAGAAGGCCACAT</a:t>
                      </a:r>
                    </a:p>
                    <a:p>
                      <a:pPr algn="l" fontAlgn="b"/>
                      <a:endParaRPr lang="en-US" sz="90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013" marR="3013" marT="3013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CTTGATCTGTTGTCACCGA</a:t>
                      </a:r>
                    </a:p>
                    <a:p>
                      <a:pPr algn="l" fontAlgn="b"/>
                      <a:endParaRPr lang="en-US" sz="90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013" marR="3013" marT="3013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</a:tbl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766004" y="2638269"/>
            <a:ext cx="50689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1 –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l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mer sequences used for real time PCR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0056369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close up of a logo&#10;&#10;Description automatically generated">
            <a:extLst>
              <a:ext uri="{FF2B5EF4-FFF2-40B4-BE49-F238E27FC236}">
                <a16:creationId xmlns:a16="http://schemas.microsoft.com/office/drawing/2014/main" id="{0FC9184D-DE4D-4F5A-9DA0-BCBF57BEFF2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0659" y="1147868"/>
            <a:ext cx="3718883" cy="4892463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990601" y="6194686"/>
            <a:ext cx="48378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 – 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an peduncle length and points of necking in H30. Distance was measured from the base of the flower head in mm; bars represent standard error. n= 11-15 as indicated. </a:t>
            </a:r>
          </a:p>
        </p:txBody>
      </p:sp>
    </p:spTree>
    <p:extLst>
      <p:ext uri="{BB962C8B-B14F-4D97-AF65-F5344CB8AC3E}">
        <p14:creationId xmlns:p14="http://schemas.microsoft.com/office/powerpoint/2010/main" val="19942157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building&#10;&#10;Description automatically generated">
            <a:extLst>
              <a:ext uri="{FF2B5EF4-FFF2-40B4-BE49-F238E27FC236}">
                <a16:creationId xmlns:a16="http://schemas.microsoft.com/office/drawing/2014/main" id="{2FFB1FD0-93DD-420B-9A32-EF61ACCE50E3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5461" y="3452495"/>
            <a:ext cx="3655060" cy="4467225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783CBA1B-567A-47A0-AAD7-D929AC4F072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25749" y="651775"/>
            <a:ext cx="2800721" cy="2800721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59E040EA-76A8-40C9-B82D-97B969C9EC85}"/>
              </a:ext>
            </a:extLst>
          </p:cNvPr>
          <p:cNvSpPr txBox="1"/>
          <p:nvPr/>
        </p:nvSpPr>
        <p:spPr>
          <a:xfrm>
            <a:off x="1854950" y="2423765"/>
            <a:ext cx="616789" cy="400110"/>
          </a:xfrm>
          <a:prstGeom prst="rect">
            <a:avLst/>
          </a:prstGeom>
          <a:noFill/>
          <a:ln w="3175">
            <a:solidFill>
              <a:schemeClr val="tx1">
                <a:lumMod val="65000"/>
                <a:lumOff val="35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/>
              <a:t>Total=</a:t>
            </a:r>
          </a:p>
          <a:p>
            <a:pPr algn="ctr"/>
            <a:r>
              <a:rPr lang="en-GB" sz="1000" b="1" dirty="0"/>
              <a:t>3, 647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2416798A-4205-4178-94EC-7346E7D2013D}"/>
              </a:ext>
            </a:extLst>
          </p:cNvPr>
          <p:cNvSpPr/>
          <p:nvPr/>
        </p:nvSpPr>
        <p:spPr>
          <a:xfrm>
            <a:off x="1203372" y="3648244"/>
            <a:ext cx="20545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7B4027E2-9016-458A-91D7-1A750A86ED46}"/>
              </a:ext>
            </a:extLst>
          </p:cNvPr>
          <p:cNvSpPr/>
          <p:nvPr/>
        </p:nvSpPr>
        <p:spPr>
          <a:xfrm>
            <a:off x="1203371" y="610774"/>
            <a:ext cx="20545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C9267FA-BF72-4739-A6E0-B7A7B43DEEF2}"/>
              </a:ext>
            </a:extLst>
          </p:cNvPr>
          <p:cNvSpPr txBox="1"/>
          <p:nvPr/>
        </p:nvSpPr>
        <p:spPr>
          <a:xfrm>
            <a:off x="412860" y="8095507"/>
            <a:ext cx="622998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. Differential gene expression amongst necking stages in cv. H3O peduncles (A)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enn diagram of differentially expressed genes between the three comparison groups: straight vs. &lt; 90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&lt; 90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s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12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&gt;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90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straight vs.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12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&gt;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90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ological process heatmap of overlapping differentially expressed genes . Up (red) and down (blue); log</a:t>
            </a:r>
            <a:r>
              <a:rPr lang="en-GB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ld change. Differentially expressed genes were calculated using DESeq2 (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djust. &lt;0.05). The heatmap was created using Morpheus (</a:t>
            </a:r>
            <a:r>
              <a:rPr lang="pt-B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rpheus</a:t>
            </a:r>
            <a:r>
              <a:rPr lang="pt-B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https://software.broadinstitute.org/morpheus) with manual annotations and the Venn diagram using Venny 2.1.0 (</a:t>
            </a:r>
            <a:r>
              <a:rPr lang="pt-B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liveros</a:t>
            </a:r>
            <a:r>
              <a:rPr lang="pt-B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2015).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9561791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29F9AD72-40B3-4BB7-A7B7-EF0AC571E024}"/>
              </a:ext>
            </a:extLst>
          </p:cNvPr>
          <p:cNvGrpSpPr/>
          <p:nvPr/>
        </p:nvGrpSpPr>
        <p:grpSpPr>
          <a:xfrm>
            <a:off x="728664" y="1278572"/>
            <a:ext cx="5400675" cy="3283069"/>
            <a:chOff x="0" y="845434"/>
            <a:chExt cx="5400675" cy="3283069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EAE85087-2430-4C97-87C5-818E0262BAA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845434"/>
              <a:ext cx="5400675" cy="3245304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DAFC887C-4297-47EE-BC2B-B5105D3118C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3079"/>
            <a:stretch/>
          </p:blipFill>
          <p:spPr>
            <a:xfrm>
              <a:off x="2164418" y="2846354"/>
              <a:ext cx="1415484" cy="1282149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9CAF8AC5-52A4-45E2-A961-A61D1C11C97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103" r="2710" b="20915"/>
            <a:stretch/>
          </p:blipFill>
          <p:spPr>
            <a:xfrm>
              <a:off x="3642248" y="2846354"/>
              <a:ext cx="1635332" cy="1001510"/>
            </a:xfrm>
            <a:prstGeom prst="rect">
              <a:avLst/>
            </a:prstGeom>
          </p:spPr>
        </p:pic>
      </p:grpSp>
      <p:sp>
        <p:nvSpPr>
          <p:cNvPr id="11" name="TextBox 10"/>
          <p:cNvSpPr txBox="1"/>
          <p:nvPr/>
        </p:nvSpPr>
        <p:spPr>
          <a:xfrm>
            <a:off x="914400" y="5197838"/>
            <a:ext cx="521493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 – 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O terms identified using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griGO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2. as up or down regulated from the ≥90° vs. straight comparison of gene expression in rose peduncles amongst the 2865 unique TAIR10 annotated genes.</a:t>
            </a:r>
          </a:p>
        </p:txBody>
      </p:sp>
    </p:spTree>
    <p:extLst>
      <p:ext uri="{BB962C8B-B14F-4D97-AF65-F5344CB8AC3E}">
        <p14:creationId xmlns:p14="http://schemas.microsoft.com/office/powerpoint/2010/main" val="86992172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7BDAE059-055E-41E4-B5EE-5C1A3723B46D}"/>
              </a:ext>
            </a:extLst>
          </p:cNvPr>
          <p:cNvGrpSpPr/>
          <p:nvPr/>
        </p:nvGrpSpPr>
        <p:grpSpPr>
          <a:xfrm>
            <a:off x="2697084" y="1207716"/>
            <a:ext cx="1463833" cy="5937181"/>
            <a:chOff x="1398344" y="129119"/>
            <a:chExt cx="1463833" cy="5937180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933BD2F6-CABC-4E7E-859A-1B83E4EB91BE}"/>
                </a:ext>
              </a:extLst>
            </p:cNvPr>
            <p:cNvGrpSpPr/>
            <p:nvPr/>
          </p:nvGrpSpPr>
          <p:grpSpPr>
            <a:xfrm>
              <a:off x="1475320" y="787406"/>
              <a:ext cx="1386857" cy="5278893"/>
              <a:chOff x="1475320" y="609599"/>
              <a:chExt cx="1386857" cy="5278893"/>
            </a:xfrm>
          </p:grpSpPr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1C64F293-F6CE-4A80-AF87-5C112CDCBA1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7311" r="84058"/>
              <a:stretch/>
            </p:blipFill>
            <p:spPr>
              <a:xfrm>
                <a:off x="1825356" y="626534"/>
                <a:ext cx="360393" cy="5149981"/>
              </a:xfrm>
              <a:prstGeom prst="rect">
                <a:avLst/>
              </a:prstGeom>
            </p:spPr>
          </p:pic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27D8662F-7631-4B7C-A2D7-D54D75D2A388}"/>
                  </a:ext>
                </a:extLst>
              </p:cNvPr>
              <p:cNvSpPr txBox="1"/>
              <p:nvPr/>
            </p:nvSpPr>
            <p:spPr>
              <a:xfrm>
                <a:off x="1475320" y="609599"/>
                <a:ext cx="489438" cy="52684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spcAft>
                    <a:spcPts val="100"/>
                  </a:spcAft>
                </a:pPr>
                <a:r>
                  <a:rPr lang="en-GB" sz="701" dirty="0"/>
                  <a:t>1 / 18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4 / 17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1 / 8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9 / 98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1 / 3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23 / 122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7 / 52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9 / 88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7 / 53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1 / 7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4 / 8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1 / 5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9 / 24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1 / 14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17 / 119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2 / 53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3 / 32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6 / 17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1 / 5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7 / 59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3 / 10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9 / 31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1 / 18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1 / 38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5 / 35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1 / 46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16 / 133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7 / 60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22 / 116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4 / 7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1 / 13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1 / 11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1 / 5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5 / 17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1 / 6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5 / 18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4 / 18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3 / 31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1 / 2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4 / 381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10 / 68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3 / 6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3 / 9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506C42FA-6CAD-4510-801D-0B29F4C45D07}"/>
                  </a:ext>
                </a:extLst>
              </p:cNvPr>
              <p:cNvSpPr txBox="1"/>
              <p:nvPr/>
            </p:nvSpPr>
            <p:spPr>
              <a:xfrm>
                <a:off x="2138433" y="619999"/>
                <a:ext cx="723744" cy="526849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spcAft>
                    <a:spcPts val="100"/>
                  </a:spcAft>
                </a:pPr>
                <a:r>
                  <a:rPr lang="en-GB" sz="701" dirty="0"/>
                  <a:t>AP2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ARF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ARR-B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B3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BRR-BPC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bHLH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bZIP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C2H2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C3H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CAMTA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CO-like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CPP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Dof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E2F/DP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ERF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FAR1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G2-like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GATA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GeBP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GRAS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GRF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HD-ZIP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HSF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LBD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MIKC-MADS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M-type_MADS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MYB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MYB_related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NAC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NF-YA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NF-YB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NF-YC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RAV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SBP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SRS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TALE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TCP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Trihelix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VOZ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WOX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WRKY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YABBY</a:t>
                </a:r>
              </a:p>
              <a:p>
                <a:pPr>
                  <a:spcAft>
                    <a:spcPts val="100"/>
                  </a:spcAft>
                </a:pPr>
                <a:r>
                  <a:rPr lang="en-GB" sz="701" dirty="0"/>
                  <a:t>ZF-HD</a:t>
                </a:r>
              </a:p>
            </p:txBody>
          </p:sp>
        </p:grp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B6BC8DD4-3AED-44BD-921D-EA389784DACC}"/>
                </a:ext>
              </a:extLst>
            </p:cNvPr>
            <p:cNvSpPr txBox="1"/>
            <p:nvPr/>
          </p:nvSpPr>
          <p:spPr>
            <a:xfrm>
              <a:off x="1398344" y="129119"/>
              <a:ext cx="1067856" cy="682771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GB" sz="701" dirty="0">
                  <a:cs typeface="Arial" panose="020B0604020202020204" pitchFamily="34" charset="0"/>
                </a:rPr>
                <a:t>Number represented out of total</a:t>
              </a:r>
            </a:p>
            <a:p>
              <a:endParaRPr lang="en-GB" sz="701" dirty="0">
                <a:cs typeface="Arial" panose="020B0604020202020204" pitchFamily="34" charset="0"/>
              </a:endParaRPr>
            </a:p>
            <a:p>
              <a:pPr>
                <a:spcAft>
                  <a:spcPts val="199"/>
                </a:spcAft>
              </a:pPr>
              <a:r>
                <a:rPr lang="en-GB" sz="701" dirty="0">
                  <a:cs typeface="Arial" panose="020B0604020202020204" pitchFamily="34" charset="0"/>
                </a:rPr>
                <a:t>&lt;90 vs Str</a:t>
              </a:r>
            </a:p>
            <a:p>
              <a:pPr>
                <a:spcAft>
                  <a:spcPts val="199"/>
                </a:spcAft>
              </a:pPr>
              <a:r>
                <a:rPr lang="en-GB" sz="701" u="sng" dirty="0">
                  <a:cs typeface="Arial" panose="020B0604020202020204" pitchFamily="34" charset="0"/>
                </a:rPr>
                <a:t>&gt;</a:t>
              </a:r>
              <a:r>
                <a:rPr lang="en-GB" sz="701" dirty="0">
                  <a:cs typeface="Arial" panose="020B0604020202020204" pitchFamily="34" charset="0"/>
                </a:rPr>
                <a:t>90 vs Str</a:t>
              </a:r>
            </a:p>
            <a:p>
              <a:endParaRPr lang="en-GB" sz="500" dirty="0">
                <a:cs typeface="Arial" panose="020B0604020202020204" pitchFamily="34" charset="0"/>
              </a:endParaRPr>
            </a:p>
            <a:p>
              <a:r>
                <a:rPr lang="en-GB" sz="701" dirty="0">
                  <a:cs typeface="Arial" panose="020B0604020202020204" pitchFamily="34" charset="0"/>
                </a:rPr>
                <a:t>TF Family</a:t>
              </a:r>
            </a:p>
          </p:txBody>
        </p: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EA996A9E-B9AA-4993-B9AA-AB6940335C61}"/>
              </a:ext>
            </a:extLst>
          </p:cNvPr>
          <p:cNvSpPr txBox="1"/>
          <p:nvPr/>
        </p:nvSpPr>
        <p:spPr>
          <a:xfrm>
            <a:off x="696823" y="7404620"/>
            <a:ext cx="5284878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5 –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atmap of differentially expressed transcription factor families, showing summarised median Log</a:t>
            </a:r>
            <a:r>
              <a:rPr lang="en-GB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ld changes. Up (red) and down (blue) log2 fold changes are shown for &lt; 90° and ≥90° in relation to straight (control) peduncles. Heatmaps were generated using Morpheus (Morpheus, https://software.broadinstitute.org/morpheus). </a:t>
            </a:r>
          </a:p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 algn="just"/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" name="Picture 10" descr="A close up of a building&#10;&#10;Description automatically generated">
            <a:extLst>
              <a:ext uri="{FF2B5EF4-FFF2-40B4-BE49-F238E27FC236}">
                <a16:creationId xmlns:a16="http://schemas.microsoft.com/office/drawing/2014/main" id="{16F676E0-33A8-40CF-B65A-41C524F20427}"/>
              </a:ext>
            </a:extLst>
          </p:cNvPr>
          <p:cNvPicPr/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478" t="5915" r="5179" b="85922"/>
          <a:stretch/>
        </p:blipFill>
        <p:spPr>
          <a:xfrm>
            <a:off x="2738887" y="831902"/>
            <a:ext cx="984250" cy="2526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11090133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close up of a map&#10;&#10;Description automatically generated">
            <a:extLst>
              <a:ext uri="{FF2B5EF4-FFF2-40B4-BE49-F238E27FC236}">
                <a16:creationId xmlns:a16="http://schemas.microsoft.com/office/drawing/2014/main" id="{9316448B-4036-45D8-B193-AC6E9111B260}"/>
              </a:ext>
            </a:extLst>
          </p:cNvPr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11" r="1613"/>
          <a:stretch/>
        </p:blipFill>
        <p:spPr bwMode="auto">
          <a:xfrm rot="5400000">
            <a:off x="1733879" y="733253"/>
            <a:ext cx="3390243" cy="5906026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B645ED27-0BE1-4A67-9BAF-FD0CEF6DF02B}"/>
              </a:ext>
            </a:extLst>
          </p:cNvPr>
          <p:cNvSpPr txBox="1"/>
          <p:nvPr/>
        </p:nvSpPr>
        <p:spPr>
          <a:xfrm>
            <a:off x="606425" y="5766836"/>
            <a:ext cx="5645150" cy="15696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6 –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nges in expression of genes in the starch and sucrose metabolism pathway in &gt;90° bent compared to straight peduncles. Pathway adapted from KEGG, annotated using Arabidopsis thaliana TAIR10 identifiers (ath00500;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anehisa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2017) and showing EC codes for enzymes. Significantly (p adjust.  &lt; 0.05) up and down regulated genes corresponding to EC codes, are shown using a red / blue colour scale respectively. Green coloured rectangles represent Arabidopsis thaliana genes that are not homologous to rose DEGs in the dataset. White boxes represent enzymes not present in Arabidopsis.</a:t>
            </a:r>
          </a:p>
        </p:txBody>
      </p:sp>
    </p:spTree>
    <p:extLst>
      <p:ext uri="{BB962C8B-B14F-4D97-AF65-F5344CB8AC3E}">
        <p14:creationId xmlns:p14="http://schemas.microsoft.com/office/powerpoint/2010/main" val="36756620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1">
            <a:extLst>
              <a:ext uri="{FF2B5EF4-FFF2-40B4-BE49-F238E27FC236}">
                <a16:creationId xmlns:a16="http://schemas.microsoft.com/office/drawing/2014/main" id="{A3A9B700-491A-4D36-862E-4EBB9AAC4C3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9679" y="1984330"/>
            <a:ext cx="539012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1" tIns="45720" rIns="91441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just" defTabSz="914362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alt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Table 2:</a:t>
            </a:r>
            <a:r>
              <a:rPr lang="en-GB" alt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 Overview of </a:t>
            </a:r>
            <a:r>
              <a:rPr lang="en-GB" alt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NAseq</a:t>
            </a:r>
            <a:r>
              <a:rPr lang="en-GB" altLang="en-US" sz="120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ata sets: quality and number of reads</a:t>
            </a:r>
            <a:endParaRPr lang="en-GB" altLang="en-US" dirty="0">
              <a:latin typeface="Arial" panose="020B0604020202020204" pitchFamily="34" charset="0"/>
            </a:endParaRPr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9326652"/>
              </p:ext>
            </p:extLst>
          </p:nvPr>
        </p:nvGraphicFramePr>
        <p:xfrm>
          <a:off x="471487" y="2898508"/>
          <a:ext cx="5915025" cy="1947217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9694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694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6123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7816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96940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067423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51837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Stage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Replicate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Total no. paired end reads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Read length (bp) 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verage (%) GC content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Mean sequence Quality Score (Phred score)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5876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62,450,157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76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46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35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5876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Straight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2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23,495,714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76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45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35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5876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3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27,028,234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76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45.5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35 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5876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73,479,001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76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46.5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35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5876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&lt;90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2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27,737,428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76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45.5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35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5876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3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25,008,791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76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45.5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35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5876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51,584,610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76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46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35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5876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&gt;90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2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22,563,926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76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45.5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35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5876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3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26,053,778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76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45.5 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35 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4947" marR="64947" marT="0" marB="0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3071146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A6D0FA1E-A89D-4DCE-B0B0-D24206CDBF3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00646772"/>
              </p:ext>
            </p:extLst>
          </p:nvPr>
        </p:nvGraphicFramePr>
        <p:xfrm>
          <a:off x="723900" y="2251832"/>
          <a:ext cx="5364163" cy="6284904"/>
        </p:xfrm>
        <a:graphic>
          <a:graphicData uri="http://schemas.openxmlformats.org/drawingml/2006/table">
            <a:tbl>
              <a:tblPr firstRow="1" firstCol="1" bandRow="1"/>
              <a:tblGrid>
                <a:gridCol w="800100">
                  <a:extLst>
                    <a:ext uri="{9D8B030D-6E8A-4147-A177-3AD203B41FA5}">
                      <a16:colId xmlns:a16="http://schemas.microsoft.com/office/drawing/2014/main" val="7462148"/>
                    </a:ext>
                  </a:extLst>
                </a:gridCol>
                <a:gridCol w="685800">
                  <a:extLst>
                    <a:ext uri="{9D8B030D-6E8A-4147-A177-3AD203B41FA5}">
                      <a16:colId xmlns:a16="http://schemas.microsoft.com/office/drawing/2014/main" val="3511574124"/>
                    </a:ext>
                  </a:extLst>
                </a:gridCol>
                <a:gridCol w="3459632">
                  <a:extLst>
                    <a:ext uri="{9D8B030D-6E8A-4147-A177-3AD203B41FA5}">
                      <a16:colId xmlns:a16="http://schemas.microsoft.com/office/drawing/2014/main" val="3146443645"/>
                    </a:ext>
                  </a:extLst>
                </a:gridCol>
                <a:gridCol w="418631">
                  <a:extLst>
                    <a:ext uri="{9D8B030D-6E8A-4147-A177-3AD203B41FA5}">
                      <a16:colId xmlns:a16="http://schemas.microsoft.com/office/drawing/2014/main" val="605298022"/>
                    </a:ext>
                  </a:extLst>
                </a:gridCol>
              </a:tblGrid>
              <a:tr h="26187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AIR10 ID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ame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escription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LFC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88498446"/>
                  </a:ext>
                </a:extLst>
              </a:tr>
              <a:tr h="26187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2G3812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UX1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ransmembrane amino acid transporter family protein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1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1.01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3D4DE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37393449"/>
                  </a:ext>
                </a:extLst>
              </a:tr>
              <a:tr h="26187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1G6837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RG1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haperone DnaJ-domain superfamily protein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34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EA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40279599"/>
                  </a:ext>
                </a:extLst>
              </a:tr>
              <a:tr h="26187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4G3502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AC3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ac</a:t>
                      </a: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like GTP-binding protein ARAC3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0.36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7BD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89922121"/>
                  </a:ext>
                </a:extLst>
              </a:tr>
              <a:tr h="26187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5G6433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PH3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hototropic-responsive NPH3 family protein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0.58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97E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99979378"/>
                  </a:ext>
                </a:extLst>
              </a:tr>
              <a:tr h="26187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2G4166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IZ1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rotein of unknown function, DUF617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1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0.82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06DE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55560192"/>
                  </a:ext>
                </a:extLst>
              </a:tr>
              <a:tr h="26187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2G1839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TN5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DP-ribosylation factor family protein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53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696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3520236"/>
                  </a:ext>
                </a:extLst>
              </a:tr>
              <a:tr h="26187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2G1482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PY2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hototropic-responsive NPH3 family protein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0.68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B86E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3557196"/>
                  </a:ext>
                </a:extLst>
              </a:tr>
              <a:tr h="26187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1G3148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GR2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hoot gravitropism 2 (SGR2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44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828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59659096"/>
                  </a:ext>
                </a:extLst>
              </a:tr>
              <a:tr h="26187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2G3691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BCB1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BC transporter B family member 1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0.72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37F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07121616"/>
                  </a:ext>
                </a:extLst>
              </a:tr>
              <a:tr h="26187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5G0275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GR9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3 ubiquitin-protein ligase SGR9, amyloplastic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1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0.95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857E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99069140"/>
                  </a:ext>
                </a:extLst>
              </a:tr>
              <a:tr h="26187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1G7359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IN1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uxin efflux carrier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0.75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E7A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98607572"/>
                  </a:ext>
                </a:extLst>
              </a:tr>
              <a:tr h="26187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1G4254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GLR3.3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Glutamate receptor 3.3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0.44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AF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23998713"/>
                  </a:ext>
                </a:extLst>
              </a:tr>
              <a:tr h="26187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3G2886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BCB19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BC transporter B family member 19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1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0.8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471E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81532387"/>
                  </a:ext>
                </a:extLst>
              </a:tr>
              <a:tr h="26187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3G5464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SA2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ryptophan synthase alpha chain, </a:t>
                      </a:r>
                      <a:r>
                        <a:rPr lang="en-US" sz="10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hloroplastic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0.26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CE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26125802"/>
                  </a:ext>
                </a:extLst>
              </a:tr>
              <a:tr h="26187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2G0194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GR5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2H2-like zinc finger protein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0.57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099E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44893315"/>
                  </a:ext>
                </a:extLst>
              </a:tr>
              <a:tr h="26187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2G0295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KS1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hytochrome kinase substrate 1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0.84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D6AE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6922517"/>
                  </a:ext>
                </a:extLst>
              </a:tr>
              <a:tr h="26187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1G5659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P3M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lathrin adaptor complexes medium subunit family protein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4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8E9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3181476"/>
                  </a:ext>
                </a:extLst>
              </a:tr>
              <a:tr h="26187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3G5422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CR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GRAS family transcription factor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0.59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C95E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30854989"/>
                  </a:ext>
                </a:extLst>
              </a:tr>
              <a:tr h="26187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2G1879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HYB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hytochrome B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0.28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7CB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00791135"/>
                  </a:ext>
                </a:extLst>
              </a:tr>
              <a:tr h="26187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5G50375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PI1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ycloeucalenol cycloisomerase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0.31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1C6F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38270959"/>
                  </a:ext>
                </a:extLst>
              </a:tr>
              <a:tr h="26187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5G5896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GIL1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lant protein of unknown function (DUF641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0.94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A59E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23363156"/>
                  </a:ext>
                </a:extLst>
              </a:tr>
              <a:tr h="26187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3G4769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B1a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icrotubule-associated protein RP/EB family member 1A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0.46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C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51790662"/>
                  </a:ext>
                </a:extLst>
              </a:tr>
              <a:tr h="26187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2G20180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18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IL5</a:t>
                      </a: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hytochrome interacting factor 3-like 5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0.53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462" marR="5646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7A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41654633"/>
                  </a:ext>
                </a:extLst>
              </a:tr>
            </a:tbl>
          </a:graphicData>
        </a:graphic>
      </p:graphicFrame>
      <p:sp>
        <p:nvSpPr>
          <p:cNvPr id="5" name="Rectangle 1">
            <a:extLst>
              <a:ext uri="{FF2B5EF4-FFF2-40B4-BE49-F238E27FC236}">
                <a16:creationId xmlns:a16="http://schemas.microsoft.com/office/drawing/2014/main" id="{0A8B0C83-349F-40B1-81F7-7C8DC66EB14E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3899" y="1513038"/>
            <a:ext cx="5364163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1" tIns="45720" rIns="91441" bIns="45720" numCol="1" anchor="ctr" anchorCtr="0" compatLnSpc="1">
            <a:prstTxWarp prst="textNoShape">
              <a:avLst/>
            </a:prstTxWarp>
            <a:spAutoFit/>
          </a:bodyPr>
          <a:lstStyle/>
          <a:p>
            <a:pPr defTabSz="914362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alt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Table 3:</a:t>
            </a:r>
            <a:r>
              <a:rPr lang="en-GB" alt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ropism-related genes whose expression changed significantly </a:t>
            </a:r>
            <a:r>
              <a:rPr lang="en-GB" alt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etween ≥90° necking and straight peduncles</a:t>
            </a:r>
            <a:r>
              <a:rPr lang="en-GB" alt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GB" alt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 adjust.</a:t>
            </a:r>
            <a:r>
              <a:rPr lang="en-GB" alt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&lt; 0.05)</a:t>
            </a:r>
            <a:r>
              <a:rPr lang="en-US" altLang="en-US" sz="110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en-US" altLang="en-US" dirty="0"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3177563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6F802052-3475-4952-A4A2-26D98F6658B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8046122"/>
              </p:ext>
            </p:extLst>
          </p:nvPr>
        </p:nvGraphicFramePr>
        <p:xfrm>
          <a:off x="782204" y="1830182"/>
          <a:ext cx="5230090" cy="1387063"/>
        </p:xfrm>
        <a:graphic>
          <a:graphicData uri="http://schemas.openxmlformats.org/drawingml/2006/table">
            <a:tbl>
              <a:tblPr firstRow="1" firstCol="1" bandRow="1"/>
              <a:tblGrid>
                <a:gridCol w="796637">
                  <a:extLst>
                    <a:ext uri="{9D8B030D-6E8A-4147-A177-3AD203B41FA5}">
                      <a16:colId xmlns:a16="http://schemas.microsoft.com/office/drawing/2014/main" val="1362451867"/>
                    </a:ext>
                  </a:extLst>
                </a:gridCol>
                <a:gridCol w="2334491">
                  <a:extLst>
                    <a:ext uri="{9D8B030D-6E8A-4147-A177-3AD203B41FA5}">
                      <a16:colId xmlns:a16="http://schemas.microsoft.com/office/drawing/2014/main" val="335508840"/>
                    </a:ext>
                  </a:extLst>
                </a:gridCol>
                <a:gridCol w="699654">
                  <a:extLst>
                    <a:ext uri="{9D8B030D-6E8A-4147-A177-3AD203B41FA5}">
                      <a16:colId xmlns:a16="http://schemas.microsoft.com/office/drawing/2014/main" val="366630188"/>
                    </a:ext>
                  </a:extLst>
                </a:gridCol>
                <a:gridCol w="699654">
                  <a:extLst>
                    <a:ext uri="{9D8B030D-6E8A-4147-A177-3AD203B41FA5}">
                      <a16:colId xmlns:a16="http://schemas.microsoft.com/office/drawing/2014/main" val="3479302077"/>
                    </a:ext>
                  </a:extLst>
                </a:gridCol>
                <a:gridCol w="699654">
                  <a:extLst>
                    <a:ext uri="{9D8B030D-6E8A-4147-A177-3AD203B41FA5}">
                      <a16:colId xmlns:a16="http://schemas.microsoft.com/office/drawing/2014/main" val="3498074223"/>
                    </a:ext>
                  </a:extLst>
                </a:gridCol>
              </a:tblGrid>
              <a:tr h="333678">
                <a:tc>
                  <a:txBody>
                    <a:bodyPr/>
                    <a:lstStyle/>
                    <a:p>
                      <a:pPr lvl="0"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EGG ID</a:t>
                      </a:r>
                    </a:p>
                  </a:txBody>
                  <a:tcPr marL="72000" marR="4769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</a:pPr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hway name</a:t>
                      </a:r>
                    </a:p>
                  </a:txBody>
                  <a:tcPr marL="72000" marR="4769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bserved</a:t>
                      </a:r>
                    </a:p>
                  </a:txBody>
                  <a:tcPr marL="72000" marR="4769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</a:t>
                      </a:r>
                    </a:p>
                  </a:txBody>
                  <a:tcPr marL="72000" marR="4769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DR</a:t>
                      </a:r>
                    </a:p>
                  </a:txBody>
                  <a:tcPr marL="72000" marR="4769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31939438"/>
                  </a:ext>
                </a:extLst>
              </a:tr>
              <a:tr h="222918">
                <a:tc>
                  <a:txBody>
                    <a:bodyPr/>
                    <a:lstStyle/>
                    <a:p>
                      <a:pPr lvl="0"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h00052</a:t>
                      </a: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lactose metabolism</a:t>
                      </a: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</a:t>
                      </a: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23</a:t>
                      </a: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930468"/>
                  </a:ext>
                </a:extLst>
              </a:tr>
              <a:tr h="222918">
                <a:tc>
                  <a:txBody>
                    <a:bodyPr/>
                    <a:lstStyle/>
                    <a:p>
                      <a:pPr lvl="0"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h00500</a:t>
                      </a: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rch and sucrose metabolism</a:t>
                      </a: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7</a:t>
                      </a: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65</a:t>
                      </a: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4239376"/>
                  </a:ext>
                </a:extLst>
              </a:tr>
              <a:tr h="222918">
                <a:tc>
                  <a:txBody>
                    <a:bodyPr/>
                    <a:lstStyle/>
                    <a:p>
                      <a:pPr lvl="0"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h01100</a:t>
                      </a: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abolic pathways</a:t>
                      </a: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</a:t>
                      </a: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99</a:t>
                      </a: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76</a:t>
                      </a: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81664684"/>
                  </a:ext>
                </a:extLst>
              </a:tr>
              <a:tr h="222918">
                <a:tc>
                  <a:txBody>
                    <a:bodyPr/>
                    <a:lstStyle/>
                    <a:p>
                      <a:pPr lvl="0"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h01110</a:t>
                      </a: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synthesis of secondary metabolites</a:t>
                      </a: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</a:t>
                      </a: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63</a:t>
                      </a: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3</a:t>
                      </a: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57819542"/>
                  </a:ext>
                </a:extLst>
              </a:tr>
              <a:tr h="161713">
                <a:tc>
                  <a:txBody>
                    <a:bodyPr/>
                    <a:lstStyle/>
                    <a:p>
                      <a:pPr lvl="0"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01830183"/>
                  </a:ext>
                </a:extLst>
              </a:tr>
            </a:tbl>
          </a:graphicData>
        </a:graphic>
      </p:graphicFrame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C662B2FC-31A1-4951-8D48-73A712C9FC4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61605164"/>
              </p:ext>
            </p:extLst>
          </p:nvPr>
        </p:nvGraphicFramePr>
        <p:xfrm>
          <a:off x="813955" y="4795687"/>
          <a:ext cx="5230090" cy="1815965"/>
        </p:xfrm>
        <a:graphic>
          <a:graphicData uri="http://schemas.openxmlformats.org/drawingml/2006/table">
            <a:tbl>
              <a:tblPr firstRow="1" firstCol="1" bandRow="1"/>
              <a:tblGrid>
                <a:gridCol w="796637">
                  <a:extLst>
                    <a:ext uri="{9D8B030D-6E8A-4147-A177-3AD203B41FA5}">
                      <a16:colId xmlns:a16="http://schemas.microsoft.com/office/drawing/2014/main" val="1362451867"/>
                    </a:ext>
                  </a:extLst>
                </a:gridCol>
                <a:gridCol w="2334491">
                  <a:extLst>
                    <a:ext uri="{9D8B030D-6E8A-4147-A177-3AD203B41FA5}">
                      <a16:colId xmlns:a16="http://schemas.microsoft.com/office/drawing/2014/main" val="335508840"/>
                    </a:ext>
                  </a:extLst>
                </a:gridCol>
                <a:gridCol w="699654">
                  <a:extLst>
                    <a:ext uri="{9D8B030D-6E8A-4147-A177-3AD203B41FA5}">
                      <a16:colId xmlns:a16="http://schemas.microsoft.com/office/drawing/2014/main" val="366630188"/>
                    </a:ext>
                  </a:extLst>
                </a:gridCol>
                <a:gridCol w="699654">
                  <a:extLst>
                    <a:ext uri="{9D8B030D-6E8A-4147-A177-3AD203B41FA5}">
                      <a16:colId xmlns:a16="http://schemas.microsoft.com/office/drawing/2014/main" val="3479302077"/>
                    </a:ext>
                  </a:extLst>
                </a:gridCol>
                <a:gridCol w="699654">
                  <a:extLst>
                    <a:ext uri="{9D8B030D-6E8A-4147-A177-3AD203B41FA5}">
                      <a16:colId xmlns:a16="http://schemas.microsoft.com/office/drawing/2014/main" val="3498074223"/>
                    </a:ext>
                  </a:extLst>
                </a:gridCol>
              </a:tblGrid>
              <a:tr h="333678">
                <a:tc>
                  <a:txBody>
                    <a:bodyPr/>
                    <a:lstStyle/>
                    <a:p>
                      <a:pPr lvl="0"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EGG ID</a:t>
                      </a:r>
                    </a:p>
                  </a:txBody>
                  <a:tcPr marL="72000" marR="4769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</a:pPr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hway name</a:t>
                      </a:r>
                    </a:p>
                  </a:txBody>
                  <a:tcPr marL="72000" marR="4769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bserved</a:t>
                      </a:r>
                    </a:p>
                  </a:txBody>
                  <a:tcPr marL="72000" marR="4769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</a:t>
                      </a:r>
                    </a:p>
                  </a:txBody>
                  <a:tcPr marL="72000" marR="4769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DR</a:t>
                      </a:r>
                    </a:p>
                  </a:txBody>
                  <a:tcPr marL="72000" marR="4769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31939438"/>
                  </a:ext>
                </a:extLst>
              </a:tr>
              <a:tr h="222918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h00196</a:t>
                      </a: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otosynthesis - antenna proteins</a:t>
                      </a: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</a:t>
                      </a: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7E-05</a:t>
                      </a: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930468"/>
                  </a:ext>
                </a:extLst>
              </a:tr>
              <a:tr h="222918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h01110</a:t>
                      </a: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synthesis of secondary metabolites</a:t>
                      </a: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</a:t>
                      </a: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63</a:t>
                      </a: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27</a:t>
                      </a: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4239376"/>
                  </a:ext>
                </a:extLst>
              </a:tr>
              <a:tr h="222918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h00195</a:t>
                      </a: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otosynthesis</a:t>
                      </a: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6</a:t>
                      </a: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68</a:t>
                      </a: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03338800"/>
                  </a:ext>
                </a:extLst>
              </a:tr>
              <a:tr h="222918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h00940</a:t>
                      </a: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enylpropanoid biosynthesis</a:t>
                      </a: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</a:t>
                      </a: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7</a:t>
                      </a: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03</a:t>
                      </a: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527324871"/>
                  </a:ext>
                </a:extLst>
              </a:tr>
              <a:tr h="222918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h00500</a:t>
                      </a: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rch and sucrose metabolism</a:t>
                      </a: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7</a:t>
                      </a: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88</a:t>
                      </a: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81664684"/>
                  </a:ext>
                </a:extLst>
              </a:tr>
              <a:tr h="222918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h01100</a:t>
                      </a: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abolic pathways</a:t>
                      </a: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4</a:t>
                      </a: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99</a:t>
                      </a: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88</a:t>
                      </a: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57819542"/>
                  </a:ext>
                </a:extLst>
              </a:tr>
              <a:tr h="139699">
                <a:tc>
                  <a:txBody>
                    <a:bodyPr/>
                    <a:lstStyle/>
                    <a:p>
                      <a:pPr lvl="0" algn="l" fontAlgn="b"/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000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01830183"/>
                  </a:ext>
                </a:extLst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813955" y="977744"/>
            <a:ext cx="506891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4(A) –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gnificantly up-regulated pathways in the ≥90° vs. straight comparison of gene expression using singular enrichment analysis (SEA) with STRING (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zklarczyk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t al., 2018).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878667" y="3940019"/>
            <a:ext cx="506891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4(B) –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gnificantly down-regulated pathways in the ≥90° vs. straight comparison of gene expression  using singular enrichment analysis (SEA) with STRING (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zklarczyk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t al., 2018).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1807241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291E16BB-A9D5-4F8C-B8E9-C9C63DE79B1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31563699"/>
              </p:ext>
            </p:extLst>
          </p:nvPr>
        </p:nvGraphicFramePr>
        <p:xfrm>
          <a:off x="560389" y="2600513"/>
          <a:ext cx="5915023" cy="4002366"/>
        </p:xfrm>
        <a:graphic>
          <a:graphicData uri="http://schemas.openxmlformats.org/drawingml/2006/table">
            <a:tbl>
              <a:tblPr firstRow="1" firstCol="1" bandRow="1"/>
              <a:tblGrid>
                <a:gridCol w="843462">
                  <a:extLst>
                    <a:ext uri="{9D8B030D-6E8A-4147-A177-3AD203B41FA5}">
                      <a16:colId xmlns:a16="http://schemas.microsoft.com/office/drawing/2014/main" val="1937886220"/>
                    </a:ext>
                  </a:extLst>
                </a:gridCol>
                <a:gridCol w="632755">
                  <a:extLst>
                    <a:ext uri="{9D8B030D-6E8A-4147-A177-3AD203B41FA5}">
                      <a16:colId xmlns:a16="http://schemas.microsoft.com/office/drawing/2014/main" val="2387508127"/>
                    </a:ext>
                  </a:extLst>
                </a:gridCol>
                <a:gridCol w="2541176">
                  <a:extLst>
                    <a:ext uri="{9D8B030D-6E8A-4147-A177-3AD203B41FA5}">
                      <a16:colId xmlns:a16="http://schemas.microsoft.com/office/drawing/2014/main" val="3701540607"/>
                    </a:ext>
                  </a:extLst>
                </a:gridCol>
                <a:gridCol w="632755">
                  <a:extLst>
                    <a:ext uri="{9D8B030D-6E8A-4147-A177-3AD203B41FA5}">
                      <a16:colId xmlns:a16="http://schemas.microsoft.com/office/drawing/2014/main" val="1260573154"/>
                    </a:ext>
                  </a:extLst>
                </a:gridCol>
                <a:gridCol w="477897">
                  <a:extLst>
                    <a:ext uri="{9D8B030D-6E8A-4147-A177-3AD203B41FA5}">
                      <a16:colId xmlns:a16="http://schemas.microsoft.com/office/drawing/2014/main" val="3249468514"/>
                    </a:ext>
                  </a:extLst>
                </a:gridCol>
                <a:gridCol w="786978">
                  <a:extLst>
                    <a:ext uri="{9D8B030D-6E8A-4147-A177-3AD203B41FA5}">
                      <a16:colId xmlns:a16="http://schemas.microsoft.com/office/drawing/2014/main" val="2607989523"/>
                    </a:ext>
                  </a:extLst>
                </a:gridCol>
              </a:tblGrid>
              <a:tr h="32176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AIT10</a:t>
                      </a: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0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D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ame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escription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ean count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LFC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FDR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59867038"/>
                  </a:ext>
                </a:extLst>
              </a:tr>
              <a:tr h="36762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4G1891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IP1-2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NOD26-like intrinsic protein 1;2 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861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0.92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BA4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.18E-05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72915566"/>
                  </a:ext>
                </a:extLst>
              </a:tr>
              <a:tr h="36762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4G1038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IP5-1 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NOD26-like intrinsic protein 5;1 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933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1.79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D4DE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.92E-24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53125495"/>
                  </a:ext>
                </a:extLst>
              </a:tr>
              <a:tr h="36762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2G4596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IP1-2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plasma membrane intrinsic protein 1B 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1807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0.67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6BCF4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.01E-04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75477637"/>
                  </a:ext>
                </a:extLst>
              </a:tr>
              <a:tr h="36762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4G0043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IP1-4 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plasma membrane intrinsic protein 1;4 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64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1.26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7681E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.19E-06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65705457"/>
                  </a:ext>
                </a:extLst>
              </a:tr>
              <a:tr h="36762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2G3717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IP2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plasma membrane intrinsic protein 2 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963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0.64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9BFF5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25E-03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80701566"/>
                  </a:ext>
                </a:extLst>
              </a:tr>
              <a:tr h="36762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4G3510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IP3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plasma membrane intrinsic protein 3 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69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1.05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8D96E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.03E-11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73253192"/>
                  </a:ext>
                </a:extLst>
              </a:tr>
              <a:tr h="36762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3G0409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IP1A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small and basic intrinsic protein 1A 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05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0.66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7BDF4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61E-02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29801332"/>
                  </a:ext>
                </a:extLst>
              </a:tr>
              <a:tr h="36762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4G0147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IP1-3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tonoplast intrinsic protein 1;3 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4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87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B5F7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08E-02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59174937"/>
                  </a:ext>
                </a:extLst>
              </a:tr>
              <a:tr h="36762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3G1624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IP2-1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delta tonoplast integral protein 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577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0.42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1D5F8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.08E-02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09457679"/>
                  </a:ext>
                </a:extLst>
              </a:tr>
              <a:tr h="36762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2G2581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IP4-1 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tonoplast intrinsic protein 4;1 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395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0.99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39CE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.60E-09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43" marR="68543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99740431"/>
                  </a:ext>
                </a:extLst>
              </a:tr>
            </a:tbl>
          </a:graphicData>
        </a:graphic>
      </p:graphicFrame>
      <p:sp>
        <p:nvSpPr>
          <p:cNvPr id="5" name="Rectangle 1">
            <a:extLst>
              <a:ext uri="{FF2B5EF4-FFF2-40B4-BE49-F238E27FC236}">
                <a16:creationId xmlns:a16="http://schemas.microsoft.com/office/drawing/2014/main" id="{F4F8A3FB-761F-4354-915D-35AA1D3839EC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0387" y="1778704"/>
            <a:ext cx="5770645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1" tIns="45720" rIns="91441" bIns="45720" numCol="1" anchor="ctr" anchorCtr="0" compatLnSpc="1">
            <a:prstTxWarp prst="textNoShape">
              <a:avLst/>
            </a:prstTxWarp>
            <a:spAutoFit/>
          </a:bodyPr>
          <a:lstStyle/>
          <a:p>
            <a:pPr defTabSz="914362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alt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Table 5</a:t>
            </a:r>
            <a:r>
              <a:rPr lang="en-GB" alt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quaporin genes whose expression changed significantly </a:t>
            </a:r>
            <a:r>
              <a:rPr lang="en-GB" alt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etween ≥90° necking and straight peduncles</a:t>
            </a:r>
            <a:r>
              <a:rPr lang="en-GB" alt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GB" alt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 adjust.</a:t>
            </a:r>
            <a:r>
              <a:rPr lang="en-GB" alt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&lt; 0.05)</a:t>
            </a:r>
            <a:endParaRPr lang="en-GB" altLang="en-US" dirty="0"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4211916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813955" y="1199993"/>
            <a:ext cx="506891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6(A) –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gnificant changes in expression in the starch and sucrose metabolism pathway genes  in the ≥90° vs. straight comparison of gene expression using KEGG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45367090"/>
              </p:ext>
            </p:extLst>
          </p:nvPr>
        </p:nvGraphicFramePr>
        <p:xfrm>
          <a:off x="463699" y="2119311"/>
          <a:ext cx="5769429" cy="6389470"/>
        </p:xfrm>
        <a:graphic>
          <a:graphicData uri="http://schemas.openxmlformats.org/drawingml/2006/table">
            <a:tbl>
              <a:tblPr firstRow="1" firstCol="1" bandRow="1"/>
              <a:tblGrid>
                <a:gridCol w="76940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30036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7298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1324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44961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563813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27785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IT10</a:t>
                      </a:r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</a:t>
                      </a:r>
                    </a:p>
                  </a:txBody>
                  <a:tcPr marL="3537" marR="3537" marT="35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me</a:t>
                      </a:r>
                    </a:p>
                  </a:txBody>
                  <a:tcPr marL="3537" marR="3537" marT="353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C number</a:t>
                      </a:r>
                    </a:p>
                  </a:txBody>
                  <a:tcPr marL="3537" marR="3537" marT="353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count</a:t>
                      </a:r>
                    </a:p>
                  </a:txBody>
                  <a:tcPr marL="3537" marR="3537" marT="353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FC</a:t>
                      </a:r>
                    </a:p>
                  </a:txBody>
                  <a:tcPr marL="3537" marR="3537" marT="353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DR</a:t>
                      </a:r>
                    </a:p>
                  </a:txBody>
                  <a:tcPr marL="3537" marR="3537" marT="3537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69767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1G02850</a:t>
                      </a:r>
                    </a:p>
                  </a:txBody>
                  <a:tcPr marL="3537" marR="3537" marT="3537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GLU11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.1.21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9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5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DACB9"/>
                    </a:solidFill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277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9767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1G11820</a:t>
                      </a:r>
                    </a:p>
                  </a:txBody>
                  <a:tcPr marL="3537" marR="3537" marT="3537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-Glycosyl hydrolases family 17 protein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.1.39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05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53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3C8F6"/>
                    </a:solidFill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799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69767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1G23870</a:t>
                      </a:r>
                    </a:p>
                  </a:txBody>
                  <a:tcPr marL="3537" marR="3537" marT="3537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PS9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.1.15; 3.1.3.12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78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2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EB0BD"/>
                    </a:solidFill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81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69767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1G32900</a:t>
                      </a:r>
                    </a:p>
                  </a:txBody>
                  <a:tcPr marL="3537" marR="3537" marT="3537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BSS1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.1.242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395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75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AB1F2"/>
                    </a:solidFill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55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69767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1G64390</a:t>
                      </a:r>
                    </a:p>
                  </a:txBody>
                  <a:tcPr marL="3537" marR="3537" marT="3537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H9C2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.1.4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74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66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4BAF4"/>
                    </a:solidFill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902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69767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1G66250</a:t>
                      </a:r>
                    </a:p>
                  </a:txBody>
                  <a:tcPr marL="3537" marR="3537" marT="3537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-Glycosyl hydrolases family 17 protein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.1.39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2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75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AB1F2"/>
                    </a:solidFill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24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69767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1G70710</a:t>
                      </a:r>
                    </a:p>
                  </a:txBody>
                  <a:tcPr marL="3537" marR="3537" marT="3537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H9B1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.1.4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72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D4DE3"/>
                    </a:solidFill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0E-11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69767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1G70730</a:t>
                      </a:r>
                    </a:p>
                  </a:txBody>
                  <a:tcPr marL="3537" marR="3537" marT="3537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GM2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4.2.2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815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9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A6B4"/>
                    </a:solidFill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0E-05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69767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1G71380</a:t>
                      </a:r>
                    </a:p>
                  </a:txBody>
                  <a:tcPr marL="3537" marR="3537" marT="3537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3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.1.4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43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D6BE7"/>
                    </a:solidFill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0E-06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69767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1G73370</a:t>
                      </a:r>
                    </a:p>
                  </a:txBody>
                  <a:tcPr marL="3537" marR="3537" marT="3537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S6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.1.13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77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EB3C0"/>
                    </a:solidFill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67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69767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1G76130</a:t>
                      </a:r>
                    </a:p>
                  </a:txBody>
                  <a:tcPr marL="3537" marR="3537" marT="3537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Y2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.1.1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7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99AA"/>
                    </a:solidFill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413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69767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2G18700</a:t>
                      </a:r>
                    </a:p>
                  </a:txBody>
                  <a:tcPr marL="3537" marR="3537" marT="3537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PS11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.1.15; 3.1.3.12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609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6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8C9F"/>
                    </a:solidFill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69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339534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2G35840</a:t>
                      </a:r>
                    </a:p>
                  </a:txBody>
                  <a:tcPr marL="3537" marR="3537" marT="3537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crose-6F-phosphate phosphohydrolase family protein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1.3.24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998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9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EC4CE"/>
                    </a:solidFill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377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69767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2G44450</a:t>
                      </a:r>
                    </a:p>
                  </a:txBody>
                  <a:tcPr marL="3537" marR="3537" marT="3537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GLU15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.1.21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8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2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738A"/>
                    </a:solidFill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122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69767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2G44480</a:t>
                      </a:r>
                    </a:p>
                  </a:txBody>
                  <a:tcPr marL="3537" marR="3537" marT="3537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GLU17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.1.21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72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DB4F3"/>
                    </a:solidFill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283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69767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3G13560</a:t>
                      </a:r>
                    </a:p>
                  </a:txBody>
                  <a:tcPr marL="3537" marR="3537" marT="3537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-Glycosyl hydrolases family 17 protein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.1.39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1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63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7BDF4"/>
                    </a:solidFill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23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69767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3G13790</a:t>
                      </a:r>
                    </a:p>
                  </a:txBody>
                  <a:tcPr marL="3537" marR="3537" marT="3537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BFRUCT1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.1.26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44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5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ACB9"/>
                    </a:solidFill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69767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3G18080</a:t>
                      </a:r>
                    </a:p>
                  </a:txBody>
                  <a:tcPr marL="3537" marR="3537" marT="3537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GLU44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.1.21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78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7AEF2"/>
                    </a:solidFill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671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69767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3G23920</a:t>
                      </a:r>
                    </a:p>
                  </a:txBody>
                  <a:tcPr marL="3537" marR="3537" marT="3537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M1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.1.2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915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6C84"/>
                    </a:solidFill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0E-06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69767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3G29320</a:t>
                      </a:r>
                    </a:p>
                  </a:txBody>
                  <a:tcPr marL="3537" marR="3537" marT="3537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S1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.1.1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65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76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B0F2"/>
                    </a:solidFill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304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69767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3G43190</a:t>
                      </a:r>
                    </a:p>
                  </a:txBody>
                  <a:tcPr marL="3537" marR="3537" marT="3537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S4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.1.13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85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85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FA7F1"/>
                    </a:solidFill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0E-05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69767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4G00490</a:t>
                      </a:r>
                    </a:p>
                  </a:txBody>
                  <a:tcPr marL="3537" marR="3537" marT="3537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M2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.1.2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1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62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9BEF4"/>
                    </a:solidFill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3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69767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4G02280</a:t>
                      </a:r>
                    </a:p>
                  </a:txBody>
                  <a:tcPr marL="3537" marR="3537" marT="3537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S3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.1.13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3036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5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EBBC6"/>
                    </a:solidFill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212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69767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4G11980</a:t>
                      </a:r>
                    </a:p>
                  </a:txBody>
                  <a:tcPr marL="3537" marR="3537" marT="3537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DX14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6.1.21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37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35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7DAF9"/>
                    </a:solidFill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493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69767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4G17770</a:t>
                      </a:r>
                    </a:p>
                  </a:txBody>
                  <a:tcPr marL="3537" marR="3537" marT="3537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PS5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.1.15; 3.1.3.12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4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62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9BEF4"/>
                    </a:solidFill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887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69767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4G22590</a:t>
                      </a:r>
                    </a:p>
                  </a:txBody>
                  <a:tcPr marL="3537" marR="3537" marT="3537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PPG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1.3.12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6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768D"/>
                    </a:solidFill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523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169767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4G24620</a:t>
                      </a:r>
                    </a:p>
                  </a:txBody>
                  <a:tcPr marL="3537" marR="3537" marT="3537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GI1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3.1.9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7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9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EB5C1"/>
                    </a:solidFill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60E-09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169767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4G29130</a:t>
                      </a:r>
                    </a:p>
                  </a:txBody>
                  <a:tcPr marL="3537" marR="3537" marT="3537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XK1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.1.1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855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3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ECDD5"/>
                    </a:solidFill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763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169767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4G39210</a:t>
                      </a:r>
                    </a:p>
                  </a:txBody>
                  <a:tcPr marL="3537" marR="3537" marT="3537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L3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.7.27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325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99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F98EE"/>
                    </a:solidFill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12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169767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5G11110</a:t>
                      </a:r>
                    </a:p>
                  </a:txBody>
                  <a:tcPr marL="3537" marR="3537" marT="3537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S2F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.1.14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5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5F79"/>
                    </a:solidFill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52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169767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5G19220</a:t>
                      </a:r>
                    </a:p>
                  </a:txBody>
                  <a:tcPr marL="3537" marR="3537" marT="3537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L1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.7.27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4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77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AFF2"/>
                    </a:solidFill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56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169767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5G20950</a:t>
                      </a:r>
                    </a:p>
                  </a:txBody>
                  <a:tcPr marL="3537" marR="3537" marT="3537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ycosyl hydrolase family protein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.1.21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7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92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79FF0"/>
                    </a:solidFill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90E-05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169767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5G48300</a:t>
                      </a:r>
                    </a:p>
                  </a:txBody>
                  <a:tcPr marL="3537" marR="3537" marT="3537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G1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.7.27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74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03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A94EE"/>
                    </a:solidFill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0E-06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3"/>
                  </a:ext>
                </a:extLst>
              </a:tr>
              <a:tr h="169767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5G54570</a:t>
                      </a:r>
                    </a:p>
                  </a:txBody>
                  <a:tcPr marL="3537" marR="3537" marT="3537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GLU41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.1.21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3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3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8196"/>
                    </a:solidFill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0E-06</a:t>
                      </a:r>
                    </a:p>
                  </a:txBody>
                  <a:tcPr marL="3537" marR="3537" marT="3537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4"/>
                  </a:ext>
                </a:extLst>
              </a:tr>
              <a:tr h="169767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5G65140</a:t>
                      </a:r>
                    </a:p>
                  </a:txBody>
                  <a:tcPr marL="3537" marR="3537" marT="3537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PPJ</a:t>
                      </a:r>
                    </a:p>
                  </a:txBody>
                  <a:tcPr marL="3537" marR="3537" marT="3537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1.3.12</a:t>
                      </a:r>
                    </a:p>
                  </a:txBody>
                  <a:tcPr marL="3537" marR="3537" marT="3537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54</a:t>
                      </a:r>
                    </a:p>
                  </a:txBody>
                  <a:tcPr marL="3537" marR="3537" marT="3537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8</a:t>
                      </a:r>
                    </a:p>
                  </a:txBody>
                  <a:tcPr marL="3537" marR="3537" marT="3537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C6A82"/>
                    </a:solidFill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20E-06</a:t>
                      </a:r>
                    </a:p>
                  </a:txBody>
                  <a:tcPr marL="3537" marR="3537" marT="3537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3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3258022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813955" y="1199995"/>
            <a:ext cx="506891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6(B) –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gnificant changes in expression in the starch and sucrose metabolism pathway genes  in the ≥90° vs. straight comparison of gene expression using KEGG, count weighted mean FC per EC number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41193768"/>
              </p:ext>
            </p:extLst>
          </p:nvPr>
        </p:nvGraphicFramePr>
        <p:xfrm>
          <a:off x="2432957" y="2421596"/>
          <a:ext cx="1638300" cy="3768089"/>
        </p:xfrm>
        <a:graphic>
          <a:graphicData uri="http://schemas.openxmlformats.org/drawingml/2006/table">
            <a:tbl>
              <a:tblPr firstRow="1" firstCol="1" bandRow="1"/>
              <a:tblGrid>
                <a:gridCol w="71437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2392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47244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C number</a:t>
                      </a:r>
                    </a:p>
                  </a:txBody>
                  <a:tcPr marL="3810" marR="3810" marT="381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unt-weighted mean LFC</a:t>
                      </a:r>
                    </a:p>
                  </a:txBody>
                  <a:tcPr marL="3810" marR="3810" marT="381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.1.15</a:t>
                      </a:r>
                    </a:p>
                  </a:txBody>
                  <a:tcPr marL="3810" marR="3810" marT="381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3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C9EA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1.3.12</a:t>
                      </a:r>
                    </a:p>
                  </a:txBody>
                  <a:tcPr marL="3810" marR="3810" marT="381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5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9BA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.1.2</a:t>
                      </a:r>
                    </a:p>
                  </a:txBody>
                  <a:tcPr marL="3810" marR="3810" marT="381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3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718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.1.21</a:t>
                      </a:r>
                    </a:p>
                  </a:txBody>
                  <a:tcPr marL="3810" marR="3810" marT="381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1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C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.1.1</a:t>
                      </a:r>
                    </a:p>
                  </a:txBody>
                  <a:tcPr marL="3810" marR="3810" marT="381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3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CBD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.1.26</a:t>
                      </a:r>
                    </a:p>
                  </a:txBody>
                  <a:tcPr marL="3810" marR="3810" marT="381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5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AAB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1.3.24</a:t>
                      </a:r>
                    </a:p>
                  </a:txBody>
                  <a:tcPr marL="3810" marR="3810" marT="381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9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C2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.1.14</a:t>
                      </a:r>
                    </a:p>
                  </a:txBody>
                  <a:tcPr marL="3810" marR="3810" marT="381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5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5F7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.1.13</a:t>
                      </a:r>
                    </a:p>
                  </a:txBody>
                  <a:tcPr marL="3810" marR="3810" marT="381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0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C1C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.1.1</a:t>
                      </a:r>
                    </a:p>
                  </a:txBody>
                  <a:tcPr marL="3810" marR="3810" marT="381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7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98A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.1.242</a:t>
                      </a:r>
                    </a:p>
                  </a:txBody>
                  <a:tcPr marL="3810" marR="3810" marT="381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75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B77E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.1.1</a:t>
                      </a:r>
                    </a:p>
                  </a:txBody>
                  <a:tcPr marL="3810" marR="3810" marT="381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76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975E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365759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.7.27</a:t>
                      </a:r>
                    </a:p>
                  </a:txBody>
                  <a:tcPr marL="3810" marR="3810" marT="381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99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D4DE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4.2.2</a:t>
                      </a:r>
                    </a:p>
                  </a:txBody>
                  <a:tcPr marL="3810" marR="3810" marT="381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9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A4B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3.1.9</a:t>
                      </a:r>
                    </a:p>
                  </a:txBody>
                  <a:tcPr marL="3810" marR="3810" marT="381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9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B3C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.1.4</a:t>
                      </a:r>
                    </a:p>
                  </a:txBody>
                  <a:tcPr marL="3810" marR="3810" marT="381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74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D79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8669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.1.39</a:t>
                      </a:r>
                    </a:p>
                  </a:txBody>
                  <a:tcPr marL="3810" marR="3810" marT="381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58</a:t>
                      </a:r>
                    </a:p>
                  </a:txBody>
                  <a:tcPr marL="3810" marR="3810" marT="381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C96E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25233367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E2211F09-2269-4AA5-9BF9-D0911739A0B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8922994"/>
              </p:ext>
            </p:extLst>
          </p:nvPr>
        </p:nvGraphicFramePr>
        <p:xfrm>
          <a:off x="728660" y="2474870"/>
          <a:ext cx="5400677" cy="2033419"/>
        </p:xfrm>
        <a:graphic>
          <a:graphicData uri="http://schemas.openxmlformats.org/drawingml/2006/table">
            <a:tbl>
              <a:tblPr firstRow="1" firstCol="1" bandRow="1"/>
              <a:tblGrid>
                <a:gridCol w="619126">
                  <a:extLst>
                    <a:ext uri="{9D8B030D-6E8A-4147-A177-3AD203B41FA5}">
                      <a16:colId xmlns:a16="http://schemas.microsoft.com/office/drawing/2014/main" val="366630188"/>
                    </a:ext>
                  </a:extLst>
                </a:gridCol>
                <a:gridCol w="790575">
                  <a:extLst>
                    <a:ext uri="{9D8B030D-6E8A-4147-A177-3AD203B41FA5}">
                      <a16:colId xmlns:a16="http://schemas.microsoft.com/office/drawing/2014/main" val="1384765077"/>
                    </a:ext>
                  </a:extLst>
                </a:gridCol>
                <a:gridCol w="371475">
                  <a:extLst>
                    <a:ext uri="{9D8B030D-6E8A-4147-A177-3AD203B41FA5}">
                      <a16:colId xmlns:a16="http://schemas.microsoft.com/office/drawing/2014/main" val="3217563961"/>
                    </a:ext>
                  </a:extLst>
                </a:gridCol>
                <a:gridCol w="857250">
                  <a:extLst>
                    <a:ext uri="{9D8B030D-6E8A-4147-A177-3AD203B41FA5}">
                      <a16:colId xmlns:a16="http://schemas.microsoft.com/office/drawing/2014/main" val="2601836844"/>
                    </a:ext>
                  </a:extLst>
                </a:gridCol>
                <a:gridCol w="381000">
                  <a:extLst>
                    <a:ext uri="{9D8B030D-6E8A-4147-A177-3AD203B41FA5}">
                      <a16:colId xmlns:a16="http://schemas.microsoft.com/office/drawing/2014/main" val="1913633726"/>
                    </a:ext>
                  </a:extLst>
                </a:gridCol>
                <a:gridCol w="838200">
                  <a:extLst>
                    <a:ext uri="{9D8B030D-6E8A-4147-A177-3AD203B41FA5}">
                      <a16:colId xmlns:a16="http://schemas.microsoft.com/office/drawing/2014/main" val="1785479790"/>
                    </a:ext>
                  </a:extLst>
                </a:gridCol>
                <a:gridCol w="438151">
                  <a:extLst>
                    <a:ext uri="{9D8B030D-6E8A-4147-A177-3AD203B41FA5}">
                      <a16:colId xmlns:a16="http://schemas.microsoft.com/office/drawing/2014/main" val="656732302"/>
                    </a:ext>
                  </a:extLst>
                </a:gridCol>
                <a:gridCol w="1104900">
                  <a:extLst>
                    <a:ext uri="{9D8B030D-6E8A-4147-A177-3AD203B41FA5}">
                      <a16:colId xmlns:a16="http://schemas.microsoft.com/office/drawing/2014/main" val="2524025154"/>
                    </a:ext>
                  </a:extLst>
                </a:gridCol>
              </a:tblGrid>
              <a:tr h="494017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</a:pPr>
                      <a:r>
                        <a:rPr lang="en-GB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er</a:t>
                      </a:r>
                    </a:p>
                  </a:txBody>
                  <a:tcPr marL="72000" marR="91441" marT="36000" marB="72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9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&lt;90 vs Str</a:t>
                      </a:r>
                    </a:p>
                  </a:txBody>
                  <a:tcPr marL="47690" marR="108000" marT="36000" marB="72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9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ig</a:t>
                      </a:r>
                    </a:p>
                  </a:txBody>
                  <a:tcPr marL="47690" marR="108000" marT="36000" marB="72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9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&gt;90 vs &lt;90</a:t>
                      </a:r>
                    </a:p>
                  </a:txBody>
                  <a:tcPr marL="47690" marR="108000" marT="36000" marB="72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9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ig</a:t>
                      </a:r>
                    </a:p>
                  </a:txBody>
                  <a:tcPr marL="47690" marR="108000" marT="36000" marB="72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540045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&gt;90 vs Str</a:t>
                      </a:r>
                    </a:p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n-GB" sz="9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7690" marR="108000" marT="36000" marB="72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9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ig</a:t>
                      </a:r>
                    </a:p>
                  </a:txBody>
                  <a:tcPr marL="47690" marR="108000" marT="36000" marB="72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9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ean count</a:t>
                      </a:r>
                    </a:p>
                  </a:txBody>
                  <a:tcPr marL="47690" marR="108000" marT="36000" marB="72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31939438"/>
                  </a:ext>
                </a:extLst>
              </a:tr>
              <a:tr h="256567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UGE5</a:t>
                      </a:r>
                    </a:p>
                  </a:txBody>
                  <a:tcPr marL="72000" marR="4769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7</a:t>
                      </a:r>
                    </a:p>
                  </a:txBody>
                  <a:tcPr marL="7619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7690" marR="108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3</a:t>
                      </a:r>
                    </a:p>
                  </a:txBody>
                  <a:tcPr marL="7619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*</a:t>
                      </a:r>
                    </a:p>
                  </a:txBody>
                  <a:tcPr marL="47690" marR="108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0</a:t>
                      </a:r>
                    </a:p>
                  </a:txBody>
                  <a:tcPr marL="7619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***</a:t>
                      </a:r>
                    </a:p>
                  </a:txBody>
                  <a:tcPr marL="47690" marR="108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,518</a:t>
                      </a:r>
                    </a:p>
                  </a:txBody>
                  <a:tcPr marL="7619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930468"/>
                  </a:ext>
                </a:extLst>
              </a:tr>
              <a:tr h="256567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IP2</a:t>
                      </a:r>
                    </a:p>
                  </a:txBody>
                  <a:tcPr marL="72000" marR="4769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0</a:t>
                      </a:r>
                    </a:p>
                  </a:txBody>
                  <a:tcPr marL="7619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7690" marR="108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3</a:t>
                      </a:r>
                    </a:p>
                  </a:txBody>
                  <a:tcPr marL="7619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7690" marR="108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3</a:t>
                      </a:r>
                    </a:p>
                  </a:txBody>
                  <a:tcPr marL="7619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**</a:t>
                      </a:r>
                    </a:p>
                  </a:txBody>
                  <a:tcPr marL="47690" marR="108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5,340</a:t>
                      </a:r>
                    </a:p>
                  </a:txBody>
                  <a:tcPr marL="7619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65790170"/>
                  </a:ext>
                </a:extLst>
              </a:tr>
              <a:tr h="256567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IN10</a:t>
                      </a:r>
                    </a:p>
                  </a:txBody>
                  <a:tcPr marL="72000" marR="4769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</a:t>
                      </a:r>
                    </a:p>
                  </a:txBody>
                  <a:tcPr marL="7619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7690" marR="1080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0</a:t>
                      </a:r>
                    </a:p>
                  </a:txBody>
                  <a:tcPr marL="7619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7690" marR="1080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9</a:t>
                      </a:r>
                    </a:p>
                  </a:txBody>
                  <a:tcPr marL="7619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*</a:t>
                      </a:r>
                    </a:p>
                  </a:txBody>
                  <a:tcPr marL="47690" marR="1080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,397</a:t>
                      </a:r>
                    </a:p>
                  </a:txBody>
                  <a:tcPr marL="7619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9134363"/>
                  </a:ext>
                </a:extLst>
              </a:tr>
              <a:tr h="256567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TBF1</a:t>
                      </a:r>
                    </a:p>
                  </a:txBody>
                  <a:tcPr marL="72000" marR="4769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8</a:t>
                      </a:r>
                    </a:p>
                  </a:txBody>
                  <a:tcPr marL="7619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7690" marR="1080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8</a:t>
                      </a:r>
                    </a:p>
                  </a:txBody>
                  <a:tcPr marL="7619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7690" marR="1080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5</a:t>
                      </a:r>
                    </a:p>
                  </a:txBody>
                  <a:tcPr marL="7619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**</a:t>
                      </a:r>
                    </a:p>
                  </a:txBody>
                  <a:tcPr marL="47690" marR="1080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,344</a:t>
                      </a:r>
                    </a:p>
                  </a:txBody>
                  <a:tcPr marL="7619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96850621"/>
                  </a:ext>
                </a:extLst>
              </a:tr>
              <a:tr h="256567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GM2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2000" marR="4769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1</a:t>
                      </a:r>
                    </a:p>
                  </a:txBody>
                  <a:tcPr marL="7619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7690" marR="1080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8</a:t>
                      </a:r>
                    </a:p>
                  </a:txBody>
                  <a:tcPr marL="7619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*</a:t>
                      </a:r>
                    </a:p>
                  </a:txBody>
                  <a:tcPr marL="47690" marR="1080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9</a:t>
                      </a:r>
                    </a:p>
                  </a:txBody>
                  <a:tcPr marL="7619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***</a:t>
                      </a:r>
                    </a:p>
                  </a:txBody>
                  <a:tcPr marL="47690" marR="1080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,820</a:t>
                      </a:r>
                    </a:p>
                  </a:txBody>
                  <a:tcPr marL="7619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3667730"/>
                  </a:ext>
                </a:extLst>
              </a:tr>
              <a:tr h="256567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GAL3</a:t>
                      </a:r>
                    </a:p>
                  </a:txBody>
                  <a:tcPr marL="72000" marR="4769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8</a:t>
                      </a:r>
                    </a:p>
                  </a:txBody>
                  <a:tcPr marL="7619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7690" marR="1080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4</a:t>
                      </a:r>
                    </a:p>
                  </a:txBody>
                  <a:tcPr marL="7619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**</a:t>
                      </a:r>
                    </a:p>
                  </a:txBody>
                  <a:tcPr marL="47690" marR="1080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2</a:t>
                      </a:r>
                    </a:p>
                  </a:txBody>
                  <a:tcPr marL="7619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***</a:t>
                      </a:r>
                    </a:p>
                  </a:txBody>
                  <a:tcPr marL="47690" marR="1080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,380</a:t>
                      </a:r>
                    </a:p>
                  </a:txBody>
                  <a:tcPr marL="7619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43957069"/>
                  </a:ext>
                </a:extLst>
              </a:tr>
            </a:tbl>
          </a:graphicData>
        </a:graphic>
      </p:graphicFrame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379D17A5-A486-4D30-949A-7474E991165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72601139"/>
              </p:ext>
            </p:extLst>
          </p:nvPr>
        </p:nvGraphicFramePr>
        <p:xfrm>
          <a:off x="728662" y="4953000"/>
          <a:ext cx="5400677" cy="2033419"/>
        </p:xfrm>
        <a:graphic>
          <a:graphicData uri="http://schemas.openxmlformats.org/drawingml/2006/table">
            <a:tbl>
              <a:tblPr firstRow="1" firstCol="1" bandRow="1"/>
              <a:tblGrid>
                <a:gridCol w="619126">
                  <a:extLst>
                    <a:ext uri="{9D8B030D-6E8A-4147-A177-3AD203B41FA5}">
                      <a16:colId xmlns:a16="http://schemas.microsoft.com/office/drawing/2014/main" val="366630188"/>
                    </a:ext>
                  </a:extLst>
                </a:gridCol>
                <a:gridCol w="790575">
                  <a:extLst>
                    <a:ext uri="{9D8B030D-6E8A-4147-A177-3AD203B41FA5}">
                      <a16:colId xmlns:a16="http://schemas.microsoft.com/office/drawing/2014/main" val="1384765077"/>
                    </a:ext>
                  </a:extLst>
                </a:gridCol>
                <a:gridCol w="371475">
                  <a:extLst>
                    <a:ext uri="{9D8B030D-6E8A-4147-A177-3AD203B41FA5}">
                      <a16:colId xmlns:a16="http://schemas.microsoft.com/office/drawing/2014/main" val="3217563961"/>
                    </a:ext>
                  </a:extLst>
                </a:gridCol>
                <a:gridCol w="857250">
                  <a:extLst>
                    <a:ext uri="{9D8B030D-6E8A-4147-A177-3AD203B41FA5}">
                      <a16:colId xmlns:a16="http://schemas.microsoft.com/office/drawing/2014/main" val="2601836844"/>
                    </a:ext>
                  </a:extLst>
                </a:gridCol>
                <a:gridCol w="381000">
                  <a:extLst>
                    <a:ext uri="{9D8B030D-6E8A-4147-A177-3AD203B41FA5}">
                      <a16:colId xmlns:a16="http://schemas.microsoft.com/office/drawing/2014/main" val="1913633726"/>
                    </a:ext>
                  </a:extLst>
                </a:gridCol>
                <a:gridCol w="838200">
                  <a:extLst>
                    <a:ext uri="{9D8B030D-6E8A-4147-A177-3AD203B41FA5}">
                      <a16:colId xmlns:a16="http://schemas.microsoft.com/office/drawing/2014/main" val="1785479790"/>
                    </a:ext>
                  </a:extLst>
                </a:gridCol>
                <a:gridCol w="438151">
                  <a:extLst>
                    <a:ext uri="{9D8B030D-6E8A-4147-A177-3AD203B41FA5}">
                      <a16:colId xmlns:a16="http://schemas.microsoft.com/office/drawing/2014/main" val="656732302"/>
                    </a:ext>
                  </a:extLst>
                </a:gridCol>
                <a:gridCol w="1104900">
                  <a:extLst>
                    <a:ext uri="{9D8B030D-6E8A-4147-A177-3AD203B41FA5}">
                      <a16:colId xmlns:a16="http://schemas.microsoft.com/office/drawing/2014/main" val="2524025154"/>
                    </a:ext>
                  </a:extLst>
                </a:gridCol>
              </a:tblGrid>
              <a:tr h="494017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</a:pPr>
                      <a:r>
                        <a:rPr lang="en-GB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er</a:t>
                      </a:r>
                    </a:p>
                  </a:txBody>
                  <a:tcPr marL="72000" marR="91441" marT="36000" marB="72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9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&lt;90 vs Str</a:t>
                      </a:r>
                    </a:p>
                  </a:txBody>
                  <a:tcPr marL="47690" marR="108000" marT="36000" marB="72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9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ig</a:t>
                      </a:r>
                    </a:p>
                  </a:txBody>
                  <a:tcPr marL="47690" marR="108000" marT="36000" marB="72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9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&gt;90 vs &lt;90</a:t>
                      </a:r>
                    </a:p>
                  </a:txBody>
                  <a:tcPr marL="47690" marR="108000" marT="36000" marB="72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9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ig</a:t>
                      </a:r>
                    </a:p>
                  </a:txBody>
                  <a:tcPr marL="47690" marR="108000" marT="36000" marB="72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540045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&gt;90 vs Str</a:t>
                      </a:r>
                    </a:p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n-GB" sz="9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7690" marR="108000" marT="36000" marB="72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9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ig</a:t>
                      </a:r>
                    </a:p>
                  </a:txBody>
                  <a:tcPr marL="47690" marR="108000" marT="36000" marB="72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9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ean count</a:t>
                      </a:r>
                    </a:p>
                  </a:txBody>
                  <a:tcPr marL="47690" marR="108000" marT="36000" marB="72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31939438"/>
                  </a:ext>
                </a:extLst>
              </a:tr>
              <a:tr h="256567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OMT1</a:t>
                      </a:r>
                    </a:p>
                  </a:txBody>
                  <a:tcPr marL="72000" marR="4769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4</a:t>
                      </a:r>
                    </a:p>
                  </a:txBody>
                  <a:tcPr marL="7619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7690" marR="108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54</a:t>
                      </a:r>
                    </a:p>
                  </a:txBody>
                  <a:tcPr marL="7619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7690" marR="108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58</a:t>
                      </a:r>
                    </a:p>
                  </a:txBody>
                  <a:tcPr marL="7619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*</a:t>
                      </a:r>
                    </a:p>
                  </a:txBody>
                  <a:tcPr marL="47690" marR="108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,490</a:t>
                      </a:r>
                    </a:p>
                  </a:txBody>
                  <a:tcPr marL="7619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930468"/>
                  </a:ext>
                </a:extLst>
              </a:tr>
              <a:tr h="256567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RXPX </a:t>
                      </a:r>
                    </a:p>
                  </a:txBody>
                  <a:tcPr marL="72000" marR="4769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60</a:t>
                      </a:r>
                    </a:p>
                  </a:txBody>
                  <a:tcPr marL="7619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7690" marR="108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68</a:t>
                      </a:r>
                    </a:p>
                  </a:txBody>
                  <a:tcPr marL="7619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*</a:t>
                      </a:r>
                    </a:p>
                  </a:txBody>
                  <a:tcPr marL="47690" marR="108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27</a:t>
                      </a:r>
                    </a:p>
                  </a:txBody>
                  <a:tcPr marL="7619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***</a:t>
                      </a:r>
                    </a:p>
                  </a:txBody>
                  <a:tcPr marL="47690" marR="108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,560</a:t>
                      </a:r>
                    </a:p>
                  </a:txBody>
                  <a:tcPr marL="7619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65790170"/>
                  </a:ext>
                </a:extLst>
              </a:tr>
              <a:tr h="256567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AD9</a:t>
                      </a:r>
                    </a:p>
                  </a:txBody>
                  <a:tcPr marL="72000" marR="4769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42</a:t>
                      </a:r>
                    </a:p>
                  </a:txBody>
                  <a:tcPr marL="7619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7690" marR="1080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35</a:t>
                      </a:r>
                    </a:p>
                  </a:txBody>
                  <a:tcPr marL="7619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7690" marR="1080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77</a:t>
                      </a:r>
                    </a:p>
                  </a:txBody>
                  <a:tcPr marL="7619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*</a:t>
                      </a:r>
                    </a:p>
                  </a:txBody>
                  <a:tcPr marL="47690" marR="1080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28</a:t>
                      </a:r>
                    </a:p>
                  </a:txBody>
                  <a:tcPr marL="7619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9134363"/>
                  </a:ext>
                </a:extLst>
              </a:tr>
              <a:tr h="256567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CT</a:t>
                      </a:r>
                    </a:p>
                  </a:txBody>
                  <a:tcPr marL="72000" marR="4769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46</a:t>
                      </a:r>
                    </a:p>
                  </a:txBody>
                  <a:tcPr marL="7619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7690" marR="1080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32</a:t>
                      </a:r>
                    </a:p>
                  </a:txBody>
                  <a:tcPr marL="7619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7690" marR="1080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78</a:t>
                      </a:r>
                    </a:p>
                  </a:txBody>
                  <a:tcPr marL="7619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**</a:t>
                      </a:r>
                    </a:p>
                  </a:txBody>
                  <a:tcPr marL="47690" marR="1080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10</a:t>
                      </a:r>
                    </a:p>
                  </a:txBody>
                  <a:tcPr marL="7619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96850621"/>
                  </a:ext>
                </a:extLst>
              </a:tr>
              <a:tr h="256567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2000" marR="4769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19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7690" marR="1080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19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7690" marR="1080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19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7690" marR="1080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19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3667730"/>
                  </a:ext>
                </a:extLst>
              </a:tr>
              <a:tr h="256567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2000" marR="4769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19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7690" marR="1080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19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7690" marR="1080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19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7690" marR="1080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19" marR="7619" marT="7619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43957069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13DAE8B2-4D7C-400B-9600-C4CF7A375307}"/>
              </a:ext>
            </a:extLst>
          </p:cNvPr>
          <p:cNvSpPr txBox="1"/>
          <p:nvPr/>
        </p:nvSpPr>
        <p:spPr>
          <a:xfrm>
            <a:off x="728660" y="1329186"/>
            <a:ext cx="540067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7 -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NA sequencing output from differential expression analysis for galactose metabolism and phenylpropanoid pathway genes chosen for qPCR analysis</a:t>
            </a:r>
          </a:p>
        </p:txBody>
      </p:sp>
    </p:spTree>
    <p:extLst>
      <p:ext uri="{BB962C8B-B14F-4D97-AF65-F5344CB8AC3E}">
        <p14:creationId xmlns:p14="http://schemas.microsoft.com/office/powerpoint/2010/main" val="265967809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BC14DA23-376A-43C5-9EAA-834266802C8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66" t="2133" r="2594" b="8523"/>
          <a:stretch/>
        </p:blipFill>
        <p:spPr>
          <a:xfrm>
            <a:off x="1179288" y="1786717"/>
            <a:ext cx="4270652" cy="250233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EC545F67-6FED-4A2E-94CA-60E7F31B9584}"/>
              </a:ext>
            </a:extLst>
          </p:cNvPr>
          <p:cNvSpPr txBox="1"/>
          <p:nvPr/>
        </p:nvSpPr>
        <p:spPr>
          <a:xfrm>
            <a:off x="1775579" y="1902898"/>
            <a:ext cx="35631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BE0A5D4-A87C-4B5D-AD8F-8E5951B74275}"/>
              </a:ext>
            </a:extLst>
          </p:cNvPr>
          <p:cNvSpPr txBox="1"/>
          <p:nvPr/>
        </p:nvSpPr>
        <p:spPr>
          <a:xfrm>
            <a:off x="2156577" y="1928177"/>
            <a:ext cx="35631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A3FA1ED-7A16-4BB3-B8DB-5B024AE783B7}"/>
              </a:ext>
            </a:extLst>
          </p:cNvPr>
          <p:cNvSpPr txBox="1"/>
          <p:nvPr/>
        </p:nvSpPr>
        <p:spPr>
          <a:xfrm>
            <a:off x="3455341" y="2133730"/>
            <a:ext cx="35631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bc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AAC19AC-3AC7-4020-BD1F-F0F7F284FC5E}"/>
              </a:ext>
            </a:extLst>
          </p:cNvPr>
          <p:cNvSpPr txBox="1"/>
          <p:nvPr/>
        </p:nvSpPr>
        <p:spPr>
          <a:xfrm>
            <a:off x="3079420" y="2133730"/>
            <a:ext cx="35631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D7F11CF-582D-44C5-88E9-138F0CEEEF27}"/>
              </a:ext>
            </a:extLst>
          </p:cNvPr>
          <p:cNvSpPr txBox="1"/>
          <p:nvPr/>
        </p:nvSpPr>
        <p:spPr>
          <a:xfrm>
            <a:off x="4413857" y="2237113"/>
            <a:ext cx="35631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2C967B1-58E8-4902-AE8C-505CFB02CABD}"/>
              </a:ext>
            </a:extLst>
          </p:cNvPr>
          <p:cNvSpPr txBox="1"/>
          <p:nvPr/>
        </p:nvSpPr>
        <p:spPr>
          <a:xfrm>
            <a:off x="4792825" y="2316765"/>
            <a:ext cx="35631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E304222-C51D-4505-91AF-04219018BFB0}"/>
              </a:ext>
            </a:extLst>
          </p:cNvPr>
          <p:cNvSpPr txBox="1"/>
          <p:nvPr/>
        </p:nvSpPr>
        <p:spPr>
          <a:xfrm>
            <a:off x="948128" y="1976034"/>
            <a:ext cx="323165" cy="157364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GB" sz="900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RFW (%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EFDFE7E-FEA2-4030-BED3-A6B089B6EEDE}"/>
              </a:ext>
            </a:extLst>
          </p:cNvPr>
          <p:cNvSpPr txBox="1"/>
          <p:nvPr/>
        </p:nvSpPr>
        <p:spPr>
          <a:xfrm>
            <a:off x="2657329" y="4173637"/>
            <a:ext cx="1636829" cy="230832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ctr"/>
            <a:r>
              <a:rPr lang="en-GB" sz="900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cking stage</a:t>
            </a: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C22CB4A2-2675-44CD-8741-58414BD759BA}"/>
              </a:ext>
            </a:extLst>
          </p:cNvPr>
          <p:cNvGrpSpPr/>
          <p:nvPr/>
        </p:nvGrpSpPr>
        <p:grpSpPr>
          <a:xfrm>
            <a:off x="3545207" y="1663352"/>
            <a:ext cx="1954333" cy="415127"/>
            <a:chOff x="3095407" y="3370763"/>
            <a:chExt cx="1954334" cy="415126"/>
          </a:xfrm>
        </p:grpSpPr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80EB8056-045E-472E-BB59-7BD3794A51C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74784" t="1831" r="13363" b="89747"/>
            <a:stretch/>
          </p:blipFill>
          <p:spPr>
            <a:xfrm>
              <a:off x="3095407" y="3370763"/>
              <a:ext cx="996357" cy="415126"/>
            </a:xfrm>
            <a:prstGeom prst="rect">
              <a:avLst/>
            </a:prstGeom>
          </p:spPr>
        </p:pic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A3C2A373-98EC-4CAB-B3CB-D1E987669C6F}"/>
                </a:ext>
              </a:extLst>
            </p:cNvPr>
            <p:cNvSpPr txBox="1"/>
            <p:nvPr/>
          </p:nvSpPr>
          <p:spPr>
            <a:xfrm>
              <a:off x="3503684" y="3474528"/>
              <a:ext cx="757097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Fuchsiana</a:t>
              </a:r>
            </a:p>
          </p:txBody>
        </p:sp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A7E76CC4-7E25-4F03-A6C1-89FFB49E0CA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83086" t="4933" r="13643" b="90691"/>
            <a:stretch/>
          </p:blipFill>
          <p:spPr>
            <a:xfrm>
              <a:off x="4120685" y="3426019"/>
              <a:ext cx="308327" cy="267308"/>
            </a:xfrm>
            <a:prstGeom prst="rect">
              <a:avLst/>
            </a:prstGeom>
          </p:spPr>
        </p:pic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D0CD3BBE-57E1-4FE7-BDE2-0855EF134625}"/>
                </a:ext>
              </a:extLst>
            </p:cNvPr>
            <p:cNvSpPr txBox="1"/>
            <p:nvPr/>
          </p:nvSpPr>
          <p:spPr>
            <a:xfrm>
              <a:off x="4371862" y="3479504"/>
              <a:ext cx="677879" cy="23083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H30</a:t>
              </a:r>
            </a:p>
          </p:txBody>
        </p:sp>
      </p:grpSp>
      <p:pic>
        <p:nvPicPr>
          <p:cNvPr id="24" name="Picture 23">
            <a:extLst>
              <a:ext uri="{FF2B5EF4-FFF2-40B4-BE49-F238E27FC236}">
                <a16:creationId xmlns:a16="http://schemas.microsoft.com/office/drawing/2014/main" id="{847F685B-B216-49E1-829F-027C236DD17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48310" y="4897858"/>
            <a:ext cx="2174852" cy="1160704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948128" y="6704352"/>
            <a:ext cx="500817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 1 – 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fresh weights of H30 and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uchsiana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lower stems at three necking stages (Straight, &lt;90° and &gt;90°). Statistical analysis was completed using a two-way ANOVA (un-balanced model), with a Tukey post-hoc test.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hows the number of stems used in the experiment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352300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88</TotalTime>
  <Words>1894</Words>
  <Application>Microsoft Office PowerPoint</Application>
  <PresentationFormat>A4 Paper (210x297 mm)</PresentationFormat>
  <Paragraphs>785</Paragraphs>
  <Slides>1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ianca lear</dc:creator>
  <cp:lastModifiedBy>Hilary Rogers</cp:lastModifiedBy>
  <cp:revision>50</cp:revision>
  <dcterms:created xsi:type="dcterms:W3CDTF">2020-06-19T06:59:41Z</dcterms:created>
  <dcterms:modified xsi:type="dcterms:W3CDTF">2022-03-08T16:18:07Z</dcterms:modified>
</cp:coreProperties>
</file>